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xlsx" ContentType="application/vnd.openxmlformats-officedocument.spreadsheetml.sheet"/>
  <Default Extension="png" ContentType="image/png"/>
  <Default Extension="bin" ContentType="application/vnd.openxmlformats-officedocument.oleObject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notesSlides/notesSlide3.xml" ContentType="application/vnd.openxmlformats-officedocument.presentationml.notesSl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notesSlides/notesSlide4.xml" ContentType="application/vnd.openxmlformats-officedocument.presentationml.notesSlid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notesSlides/notesSlide5.xml" ContentType="application/vnd.openxmlformats-officedocument.presentationml.notesSlid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8"/>
  </p:notesMasterIdLst>
  <p:sldIdLst>
    <p:sldId id="258" r:id="rId2"/>
    <p:sldId id="272" r:id="rId3"/>
    <p:sldId id="257" r:id="rId4"/>
    <p:sldId id="273" r:id="rId5"/>
    <p:sldId id="270" r:id="rId6"/>
    <p:sldId id="269" r:id="rId7"/>
  </p:sldIdLst>
  <p:sldSz cx="28800425" cy="28800425"/>
  <p:notesSz cx="9144000" cy="6858000"/>
  <p:defaultTextStyle>
    <a:defPPr>
      <a:defRPr lang="en-US"/>
    </a:defPPr>
    <a:lvl1pPr marL="0" algn="l" defTabSz="2332712" rtl="0" eaLnBrk="1" latinLnBrk="0" hangingPunct="1">
      <a:defRPr sz="4593" kern="1200">
        <a:solidFill>
          <a:schemeClr val="tx1"/>
        </a:solidFill>
        <a:latin typeface="+mn-lt"/>
        <a:ea typeface="+mn-ea"/>
        <a:cs typeface="+mn-cs"/>
      </a:defRPr>
    </a:lvl1pPr>
    <a:lvl2pPr marL="1166356" algn="l" defTabSz="2332712" rtl="0" eaLnBrk="1" latinLnBrk="0" hangingPunct="1">
      <a:defRPr sz="4593" kern="1200">
        <a:solidFill>
          <a:schemeClr val="tx1"/>
        </a:solidFill>
        <a:latin typeface="+mn-lt"/>
        <a:ea typeface="+mn-ea"/>
        <a:cs typeface="+mn-cs"/>
      </a:defRPr>
    </a:lvl2pPr>
    <a:lvl3pPr marL="2332712" algn="l" defTabSz="2332712" rtl="0" eaLnBrk="1" latinLnBrk="0" hangingPunct="1">
      <a:defRPr sz="4593" kern="1200">
        <a:solidFill>
          <a:schemeClr val="tx1"/>
        </a:solidFill>
        <a:latin typeface="+mn-lt"/>
        <a:ea typeface="+mn-ea"/>
        <a:cs typeface="+mn-cs"/>
      </a:defRPr>
    </a:lvl3pPr>
    <a:lvl4pPr marL="3499070" algn="l" defTabSz="2332712" rtl="0" eaLnBrk="1" latinLnBrk="0" hangingPunct="1">
      <a:defRPr sz="4593" kern="1200">
        <a:solidFill>
          <a:schemeClr val="tx1"/>
        </a:solidFill>
        <a:latin typeface="+mn-lt"/>
        <a:ea typeface="+mn-ea"/>
        <a:cs typeface="+mn-cs"/>
      </a:defRPr>
    </a:lvl4pPr>
    <a:lvl5pPr marL="4665426" algn="l" defTabSz="2332712" rtl="0" eaLnBrk="1" latinLnBrk="0" hangingPunct="1">
      <a:defRPr sz="4593" kern="1200">
        <a:solidFill>
          <a:schemeClr val="tx1"/>
        </a:solidFill>
        <a:latin typeface="+mn-lt"/>
        <a:ea typeface="+mn-ea"/>
        <a:cs typeface="+mn-cs"/>
      </a:defRPr>
    </a:lvl5pPr>
    <a:lvl6pPr marL="5831782" algn="l" defTabSz="2332712" rtl="0" eaLnBrk="1" latinLnBrk="0" hangingPunct="1">
      <a:defRPr sz="4593" kern="1200">
        <a:solidFill>
          <a:schemeClr val="tx1"/>
        </a:solidFill>
        <a:latin typeface="+mn-lt"/>
        <a:ea typeface="+mn-ea"/>
        <a:cs typeface="+mn-cs"/>
      </a:defRPr>
    </a:lvl6pPr>
    <a:lvl7pPr marL="6998138" algn="l" defTabSz="2332712" rtl="0" eaLnBrk="1" latinLnBrk="0" hangingPunct="1">
      <a:defRPr sz="4593" kern="1200">
        <a:solidFill>
          <a:schemeClr val="tx1"/>
        </a:solidFill>
        <a:latin typeface="+mn-lt"/>
        <a:ea typeface="+mn-ea"/>
        <a:cs typeface="+mn-cs"/>
      </a:defRPr>
    </a:lvl7pPr>
    <a:lvl8pPr marL="8164496" algn="l" defTabSz="2332712" rtl="0" eaLnBrk="1" latinLnBrk="0" hangingPunct="1">
      <a:defRPr sz="4593" kern="1200">
        <a:solidFill>
          <a:schemeClr val="tx1"/>
        </a:solidFill>
        <a:latin typeface="+mn-lt"/>
        <a:ea typeface="+mn-ea"/>
        <a:cs typeface="+mn-cs"/>
      </a:defRPr>
    </a:lvl8pPr>
    <a:lvl9pPr marL="9330852" algn="l" defTabSz="2332712" rtl="0" eaLnBrk="1" latinLnBrk="0" hangingPunct="1">
      <a:defRPr sz="4593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3CC33"/>
    <a:srgbClr val="FFFFFF"/>
    <a:srgbClr val="0099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581" autoAdjust="0"/>
    <p:restoredTop sz="86329" autoAdjust="0"/>
  </p:normalViewPr>
  <p:slideViewPr>
    <p:cSldViewPr snapToGrid="0">
      <p:cViewPr varScale="1">
        <p:scale>
          <a:sx n="23" d="100"/>
          <a:sy n="23" d="100"/>
        </p:scale>
        <p:origin x="2368" y="2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theme" Target="theme/theme1.xml"/><Relationship Id="rId12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notesMaster" Target="notesMasters/notesMaster1.xml"/><Relationship Id="rId9" Type="http://schemas.openxmlformats.org/officeDocument/2006/relationships/presProps" Target="presProps.xml"/><Relationship Id="rId10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microsoft.com/office/2011/relationships/chartStyle" Target="style1.xml"/><Relationship Id="rId2" Type="http://schemas.microsoft.com/office/2011/relationships/chartColorStyle" Target="colors1.xml"/><Relationship Id="rId3" Type="http://schemas.openxmlformats.org/officeDocument/2006/relationships/package" Target="../embeddings/Microsoft_Excel_Worksheet1.xlsx"/></Relationships>
</file>

<file path=ppt/charts/_rels/chart2.xml.rels><?xml version="1.0" encoding="UTF-8" standalone="yes"?>
<Relationships xmlns="http://schemas.openxmlformats.org/package/2006/relationships"><Relationship Id="rId1" Type="http://schemas.microsoft.com/office/2011/relationships/chartStyle" Target="style2.xml"/><Relationship Id="rId2" Type="http://schemas.microsoft.com/office/2011/relationships/chartColorStyle" Target="colors2.xml"/><Relationship Id="rId3" Type="http://schemas.openxmlformats.org/officeDocument/2006/relationships/package" Target="../embeddings/Microsoft_Excel_Worksheet2.xlsx"/></Relationships>
</file>

<file path=ppt/charts/_rels/chart3.xml.rels><?xml version="1.0" encoding="UTF-8" standalone="yes"?>
<Relationships xmlns="http://schemas.openxmlformats.org/package/2006/relationships"><Relationship Id="rId1" Type="http://schemas.microsoft.com/office/2011/relationships/chartStyle" Target="style3.xml"/><Relationship Id="rId2" Type="http://schemas.microsoft.com/office/2011/relationships/chartColorStyle" Target="colors3.xml"/><Relationship Id="rId3" Type="http://schemas.openxmlformats.org/officeDocument/2006/relationships/package" Target="../embeddings/Microsoft_Excel_Worksheet3.xlsx"/></Relationships>
</file>

<file path=ppt/charts/_rels/chart4.xml.rels><?xml version="1.0" encoding="UTF-8" standalone="yes"?>
<Relationships xmlns="http://schemas.openxmlformats.org/package/2006/relationships"><Relationship Id="rId1" Type="http://schemas.microsoft.com/office/2011/relationships/chartStyle" Target="style4.xml"/><Relationship Id="rId2" Type="http://schemas.microsoft.com/office/2011/relationships/chartColorStyle" Target="colors4.xml"/><Relationship Id="rId3" Type="http://schemas.openxmlformats.org/officeDocument/2006/relationships/package" Target="../embeddings/Microsoft_Excel_Worksheet4.xlsx"/></Relationships>
</file>

<file path=ppt/charts/_rels/chart5.xml.rels><?xml version="1.0" encoding="UTF-8" standalone="yes"?>
<Relationships xmlns="http://schemas.openxmlformats.org/package/2006/relationships"><Relationship Id="rId1" Type="http://schemas.microsoft.com/office/2011/relationships/chartStyle" Target="style5.xml"/><Relationship Id="rId2" Type="http://schemas.microsoft.com/office/2011/relationships/chartColorStyle" Target="colors5.xml"/><Relationship Id="rId3" Type="http://schemas.openxmlformats.org/officeDocument/2006/relationships/oleObject" Target="../embeddings/oleObject1.bin"/></Relationships>
</file>

<file path=ppt/charts/_rels/chart6.xml.rels><?xml version="1.0" encoding="UTF-8" standalone="yes"?>
<Relationships xmlns="http://schemas.openxmlformats.org/package/2006/relationships"><Relationship Id="rId1" Type="http://schemas.microsoft.com/office/2011/relationships/chartStyle" Target="style6.xml"/><Relationship Id="rId2" Type="http://schemas.microsoft.com/office/2011/relationships/chartColorStyle" Target="colors6.xml"/><Relationship Id="rId3" Type="http://schemas.openxmlformats.org/officeDocument/2006/relationships/oleObject" Target="../embeddings/oleObject2.bin"/></Relationships>
</file>

<file path=ppt/charts/_rels/chart7.xml.rels><?xml version="1.0" encoding="UTF-8" standalone="yes"?>
<Relationships xmlns="http://schemas.openxmlformats.org/package/2006/relationships"><Relationship Id="rId1" Type="http://schemas.microsoft.com/office/2011/relationships/chartStyle" Target="style7.xml"/><Relationship Id="rId2" Type="http://schemas.microsoft.com/office/2011/relationships/chartColorStyle" Target="colors7.xml"/><Relationship Id="rId3" Type="http://schemas.openxmlformats.org/officeDocument/2006/relationships/oleObject" Target="../embeddings/oleObject3.bin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735267572705962"/>
          <c:y val="0.0501535279912738"/>
          <c:w val="0.831431710774473"/>
          <c:h val="0.611177414226537"/>
        </c:manualLayout>
      </c:layout>
      <c:barChart>
        <c:barDir val="col"/>
        <c:grouping val="stacked"/>
        <c:varyColors val="0"/>
        <c:ser>
          <c:idx val="0"/>
          <c:order val="0"/>
          <c:tx>
            <c:strRef>
              <c:f>'Sheet1 (2)'!$B$1</c:f>
              <c:strCache>
                <c:ptCount val="1"/>
                <c:pt idx="0">
                  <c:v>Mapped</c:v>
                </c:pt>
              </c:strCache>
            </c:strRef>
          </c:tx>
          <c:spPr>
            <a:solidFill>
              <a:srgbClr val="FF6600"/>
            </a:solidFill>
            <a:ln>
              <a:solidFill>
                <a:srgbClr val="FF6600"/>
              </a:solidFill>
            </a:ln>
            <a:effectLst/>
          </c:spPr>
          <c:invertIfNegative val="0"/>
          <c:cat>
            <c:strRef>
              <c:f>'Sheet1 (2)'!$A$2:$A$37</c:f>
              <c:strCache>
                <c:ptCount val="36"/>
                <c:pt idx="0">
                  <c:v>Shoot infected, 17 dpi, R1</c:v>
                </c:pt>
                <c:pt idx="1">
                  <c:v>Shoot infected, 17 dpi, R2</c:v>
                </c:pt>
                <c:pt idx="2">
                  <c:v>Shoot infected, 17 dpi, R3</c:v>
                </c:pt>
                <c:pt idx="3">
                  <c:v>Shoot infected, 20 dpi, R1</c:v>
                </c:pt>
                <c:pt idx="4">
                  <c:v>Shoot infected, 20 dpi, R2</c:v>
                </c:pt>
                <c:pt idx="5">
                  <c:v>Shoot infected, 20 dpi, R3</c:v>
                </c:pt>
                <c:pt idx="6">
                  <c:v>Shoot infected, 24 dpi, R1</c:v>
                </c:pt>
                <c:pt idx="7">
                  <c:v>Shoot infected, 24 dpi, R2</c:v>
                </c:pt>
                <c:pt idx="8">
                  <c:v>Shoot infected, 24 dpi, R3</c:v>
                </c:pt>
                <c:pt idx="9">
                  <c:v>Root infected, 17 dpi, R1</c:v>
                </c:pt>
                <c:pt idx="10">
                  <c:v>Root infected, 17 dpi, R2</c:v>
                </c:pt>
                <c:pt idx="11">
                  <c:v>Root infected, 17 dpi, R3</c:v>
                </c:pt>
                <c:pt idx="12">
                  <c:v>Root infected, 20 dpi, R1</c:v>
                </c:pt>
                <c:pt idx="13">
                  <c:v>Root infected, 20 dpi, R2</c:v>
                </c:pt>
                <c:pt idx="14">
                  <c:v>Root infected, 20 dpi, R3</c:v>
                </c:pt>
                <c:pt idx="15">
                  <c:v>Root infected, 24 dpi, R1</c:v>
                </c:pt>
                <c:pt idx="16">
                  <c:v>Root infected, 24 dpi, R2</c:v>
                </c:pt>
                <c:pt idx="17">
                  <c:v>Root infected, 24 dpi, R3</c:v>
                </c:pt>
                <c:pt idx="18">
                  <c:v>Shoot uninfected, 17 dpi, R1</c:v>
                </c:pt>
                <c:pt idx="19">
                  <c:v>Shoot uninfected, 17 dpi, R2</c:v>
                </c:pt>
                <c:pt idx="20">
                  <c:v>Shoot uninfected, 17 dpi, R3</c:v>
                </c:pt>
                <c:pt idx="21">
                  <c:v>Shoot uninfected, 20 dpi, R1</c:v>
                </c:pt>
                <c:pt idx="22">
                  <c:v>Shoot uninfected, 20 dpi, R2</c:v>
                </c:pt>
                <c:pt idx="23">
                  <c:v>Shoot uninfected, 20 dpi, R3</c:v>
                </c:pt>
                <c:pt idx="24">
                  <c:v>Shoot uninfected, 24 dpi, R1</c:v>
                </c:pt>
                <c:pt idx="25">
                  <c:v>Shoot uninfected, 24 dpi, R2</c:v>
                </c:pt>
                <c:pt idx="26">
                  <c:v>Shoot uninfected, 24 dpi, R3</c:v>
                </c:pt>
                <c:pt idx="27">
                  <c:v>Root uninfected, 17 dpi, R1</c:v>
                </c:pt>
                <c:pt idx="28">
                  <c:v>Root uninfected, 17 dpi, R2</c:v>
                </c:pt>
                <c:pt idx="29">
                  <c:v>Root uninfected, 17 dpi, R3</c:v>
                </c:pt>
                <c:pt idx="30">
                  <c:v>Root uninfected, 20 dpi, R1</c:v>
                </c:pt>
                <c:pt idx="31">
                  <c:v>Root uninfected, 20 dpi, R2</c:v>
                </c:pt>
                <c:pt idx="32">
                  <c:v>Root uninfected, 20 dpi, R3</c:v>
                </c:pt>
                <c:pt idx="33">
                  <c:v>Root uninfected, 24 dpi, R1</c:v>
                </c:pt>
                <c:pt idx="34">
                  <c:v>Root uninfected, 24 dpi, R2</c:v>
                </c:pt>
                <c:pt idx="35">
                  <c:v>Root uninfected, 24 dpi, R3</c:v>
                </c:pt>
              </c:strCache>
            </c:strRef>
          </c:cat>
          <c:val>
            <c:numRef>
              <c:f>'Sheet1 (2)'!$B$2:$B$37</c:f>
              <c:numCache>
                <c:formatCode>General</c:formatCode>
                <c:ptCount val="36"/>
                <c:pt idx="0">
                  <c:v>16.850948</c:v>
                </c:pt>
                <c:pt idx="1">
                  <c:v>23.649494</c:v>
                </c:pt>
                <c:pt idx="2">
                  <c:v>21.92064999999999</c:v>
                </c:pt>
                <c:pt idx="3">
                  <c:v>18.754484</c:v>
                </c:pt>
                <c:pt idx="4">
                  <c:v>21.2937</c:v>
                </c:pt>
                <c:pt idx="5">
                  <c:v>32.067826</c:v>
                </c:pt>
                <c:pt idx="6">
                  <c:v>40.867262</c:v>
                </c:pt>
                <c:pt idx="7">
                  <c:v>23.100694</c:v>
                </c:pt>
                <c:pt idx="8">
                  <c:v>33.59742600000001</c:v>
                </c:pt>
                <c:pt idx="9">
                  <c:v>52.491686</c:v>
                </c:pt>
                <c:pt idx="10">
                  <c:v>21.40935</c:v>
                </c:pt>
                <c:pt idx="11">
                  <c:v>17.84841399999999</c:v>
                </c:pt>
                <c:pt idx="12">
                  <c:v>25.19575</c:v>
                </c:pt>
                <c:pt idx="13">
                  <c:v>26.35546799999999</c:v>
                </c:pt>
                <c:pt idx="14">
                  <c:v>27.605076</c:v>
                </c:pt>
                <c:pt idx="15">
                  <c:v>24.689084</c:v>
                </c:pt>
                <c:pt idx="16">
                  <c:v>26.530888</c:v>
                </c:pt>
                <c:pt idx="17">
                  <c:v>24.82456000000001</c:v>
                </c:pt>
                <c:pt idx="18">
                  <c:v>32.544374</c:v>
                </c:pt>
                <c:pt idx="19">
                  <c:v>21.804368</c:v>
                </c:pt>
                <c:pt idx="20">
                  <c:v>11.92973</c:v>
                </c:pt>
                <c:pt idx="21">
                  <c:v>32.9047</c:v>
                </c:pt>
                <c:pt idx="22">
                  <c:v>23.010956</c:v>
                </c:pt>
                <c:pt idx="23">
                  <c:v>18.36473</c:v>
                </c:pt>
                <c:pt idx="24">
                  <c:v>21.501228</c:v>
                </c:pt>
                <c:pt idx="25">
                  <c:v>24.31581600000001</c:v>
                </c:pt>
                <c:pt idx="26">
                  <c:v>28.42616</c:v>
                </c:pt>
                <c:pt idx="27">
                  <c:v>23.62511599999999</c:v>
                </c:pt>
                <c:pt idx="28">
                  <c:v>28.130916</c:v>
                </c:pt>
                <c:pt idx="29">
                  <c:v>27.29966</c:v>
                </c:pt>
                <c:pt idx="30">
                  <c:v>42.861902</c:v>
                </c:pt>
                <c:pt idx="31">
                  <c:v>28.245684</c:v>
                </c:pt>
                <c:pt idx="32">
                  <c:v>19.857416</c:v>
                </c:pt>
                <c:pt idx="33">
                  <c:v>27.73651</c:v>
                </c:pt>
                <c:pt idx="34">
                  <c:v>23.713582</c:v>
                </c:pt>
                <c:pt idx="35">
                  <c:v>22.298752</c:v>
                </c:pt>
              </c:numCache>
            </c:numRef>
          </c:val>
        </c:ser>
        <c:ser>
          <c:idx val="1"/>
          <c:order val="1"/>
          <c:tx>
            <c:strRef>
              <c:f>'Sheet1 (2)'!$C$1</c:f>
              <c:strCache>
                <c:ptCount val="1"/>
                <c:pt idx="0">
                  <c:v>Unmapped</c:v>
                </c:pt>
              </c:strCache>
            </c:strRef>
          </c:tx>
          <c:spPr>
            <a:solidFill>
              <a:srgbClr val="00B0F0"/>
            </a:solidFill>
            <a:ln>
              <a:solidFill>
                <a:schemeClr val="accent1">
                  <a:lumMod val="75000"/>
                </a:schemeClr>
              </a:solidFill>
            </a:ln>
            <a:effectLst/>
          </c:spPr>
          <c:invertIfNegative val="0"/>
          <c:cat>
            <c:strRef>
              <c:f>'Sheet1 (2)'!$A$2:$A$37</c:f>
              <c:strCache>
                <c:ptCount val="36"/>
                <c:pt idx="0">
                  <c:v>Shoot infected, 17 dpi, R1</c:v>
                </c:pt>
                <c:pt idx="1">
                  <c:v>Shoot infected, 17 dpi, R2</c:v>
                </c:pt>
                <c:pt idx="2">
                  <c:v>Shoot infected, 17 dpi, R3</c:v>
                </c:pt>
                <c:pt idx="3">
                  <c:v>Shoot infected, 20 dpi, R1</c:v>
                </c:pt>
                <c:pt idx="4">
                  <c:v>Shoot infected, 20 dpi, R2</c:v>
                </c:pt>
                <c:pt idx="5">
                  <c:v>Shoot infected, 20 dpi, R3</c:v>
                </c:pt>
                <c:pt idx="6">
                  <c:v>Shoot infected, 24 dpi, R1</c:v>
                </c:pt>
                <c:pt idx="7">
                  <c:v>Shoot infected, 24 dpi, R2</c:v>
                </c:pt>
                <c:pt idx="8">
                  <c:v>Shoot infected, 24 dpi, R3</c:v>
                </c:pt>
                <c:pt idx="9">
                  <c:v>Root infected, 17 dpi, R1</c:v>
                </c:pt>
                <c:pt idx="10">
                  <c:v>Root infected, 17 dpi, R2</c:v>
                </c:pt>
                <c:pt idx="11">
                  <c:v>Root infected, 17 dpi, R3</c:v>
                </c:pt>
                <c:pt idx="12">
                  <c:v>Root infected, 20 dpi, R1</c:v>
                </c:pt>
                <c:pt idx="13">
                  <c:v>Root infected, 20 dpi, R2</c:v>
                </c:pt>
                <c:pt idx="14">
                  <c:v>Root infected, 20 dpi, R3</c:v>
                </c:pt>
                <c:pt idx="15">
                  <c:v>Root infected, 24 dpi, R1</c:v>
                </c:pt>
                <c:pt idx="16">
                  <c:v>Root infected, 24 dpi, R2</c:v>
                </c:pt>
                <c:pt idx="17">
                  <c:v>Root infected, 24 dpi, R3</c:v>
                </c:pt>
                <c:pt idx="18">
                  <c:v>Shoot uninfected, 17 dpi, R1</c:v>
                </c:pt>
                <c:pt idx="19">
                  <c:v>Shoot uninfected, 17 dpi, R2</c:v>
                </c:pt>
                <c:pt idx="20">
                  <c:v>Shoot uninfected, 17 dpi, R3</c:v>
                </c:pt>
                <c:pt idx="21">
                  <c:v>Shoot uninfected, 20 dpi, R1</c:v>
                </c:pt>
                <c:pt idx="22">
                  <c:v>Shoot uninfected, 20 dpi, R2</c:v>
                </c:pt>
                <c:pt idx="23">
                  <c:v>Shoot uninfected, 20 dpi, R3</c:v>
                </c:pt>
                <c:pt idx="24">
                  <c:v>Shoot uninfected, 24 dpi, R1</c:v>
                </c:pt>
                <c:pt idx="25">
                  <c:v>Shoot uninfected, 24 dpi, R2</c:v>
                </c:pt>
                <c:pt idx="26">
                  <c:v>Shoot uninfected, 24 dpi, R3</c:v>
                </c:pt>
                <c:pt idx="27">
                  <c:v>Root uninfected, 17 dpi, R1</c:v>
                </c:pt>
                <c:pt idx="28">
                  <c:v>Root uninfected, 17 dpi, R2</c:v>
                </c:pt>
                <c:pt idx="29">
                  <c:v>Root uninfected, 17 dpi, R3</c:v>
                </c:pt>
                <c:pt idx="30">
                  <c:v>Root uninfected, 20 dpi, R1</c:v>
                </c:pt>
                <c:pt idx="31">
                  <c:v>Root uninfected, 20 dpi, R2</c:v>
                </c:pt>
                <c:pt idx="32">
                  <c:v>Root uninfected, 20 dpi, R3</c:v>
                </c:pt>
                <c:pt idx="33">
                  <c:v>Root uninfected, 24 dpi, R1</c:v>
                </c:pt>
                <c:pt idx="34">
                  <c:v>Root uninfected, 24 dpi, R2</c:v>
                </c:pt>
                <c:pt idx="35">
                  <c:v>Root uninfected, 24 dpi, R3</c:v>
                </c:pt>
              </c:strCache>
            </c:strRef>
          </c:cat>
          <c:val>
            <c:numRef>
              <c:f>'Sheet1 (2)'!$C$2:$C$37</c:f>
              <c:numCache>
                <c:formatCode>General</c:formatCode>
                <c:ptCount val="36"/>
                <c:pt idx="0">
                  <c:v>1.047192</c:v>
                </c:pt>
                <c:pt idx="1">
                  <c:v>1.142868</c:v>
                </c:pt>
                <c:pt idx="2">
                  <c:v>1.098686</c:v>
                </c:pt>
                <c:pt idx="3">
                  <c:v>1.283898</c:v>
                </c:pt>
                <c:pt idx="4">
                  <c:v>1.428362</c:v>
                </c:pt>
                <c:pt idx="5">
                  <c:v>1.855722</c:v>
                </c:pt>
                <c:pt idx="6">
                  <c:v>3.229346</c:v>
                </c:pt>
                <c:pt idx="7">
                  <c:v>1.37477</c:v>
                </c:pt>
                <c:pt idx="8">
                  <c:v>1.740674</c:v>
                </c:pt>
                <c:pt idx="9">
                  <c:v>3.856009999999999</c:v>
                </c:pt>
                <c:pt idx="10">
                  <c:v>1.121076</c:v>
                </c:pt>
                <c:pt idx="11">
                  <c:v>1.439144</c:v>
                </c:pt>
                <c:pt idx="12">
                  <c:v>1.433612</c:v>
                </c:pt>
                <c:pt idx="13">
                  <c:v>1.677378</c:v>
                </c:pt>
                <c:pt idx="14">
                  <c:v>1.990196</c:v>
                </c:pt>
                <c:pt idx="15">
                  <c:v>2.326916</c:v>
                </c:pt>
                <c:pt idx="16">
                  <c:v>1.994892</c:v>
                </c:pt>
                <c:pt idx="17">
                  <c:v>2.488284</c:v>
                </c:pt>
                <c:pt idx="18">
                  <c:v>1.791394</c:v>
                </c:pt>
                <c:pt idx="19">
                  <c:v>1.379822</c:v>
                </c:pt>
                <c:pt idx="20">
                  <c:v>0.705162</c:v>
                </c:pt>
                <c:pt idx="21">
                  <c:v>2.059553999999999</c:v>
                </c:pt>
                <c:pt idx="22">
                  <c:v>1.378686</c:v>
                </c:pt>
                <c:pt idx="23">
                  <c:v>1.057908</c:v>
                </c:pt>
                <c:pt idx="24">
                  <c:v>1.267412</c:v>
                </c:pt>
                <c:pt idx="25">
                  <c:v>1.36995</c:v>
                </c:pt>
                <c:pt idx="26">
                  <c:v>1.67317</c:v>
                </c:pt>
                <c:pt idx="27">
                  <c:v>1.87095</c:v>
                </c:pt>
                <c:pt idx="28">
                  <c:v>1.778006</c:v>
                </c:pt>
                <c:pt idx="29">
                  <c:v>1.492612</c:v>
                </c:pt>
                <c:pt idx="30">
                  <c:v>2.534104</c:v>
                </c:pt>
                <c:pt idx="31">
                  <c:v>2.399347999999999</c:v>
                </c:pt>
                <c:pt idx="32">
                  <c:v>1.678908</c:v>
                </c:pt>
                <c:pt idx="33">
                  <c:v>1.519252</c:v>
                </c:pt>
                <c:pt idx="34">
                  <c:v>1.28749</c:v>
                </c:pt>
                <c:pt idx="35">
                  <c:v>1.21712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-826028368"/>
        <c:axId val="-813469584"/>
      </c:barChart>
      <c:catAx>
        <c:axId val="-826028368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3000000" spcFirstLastPara="1" vertOverflow="ellipsis" wrap="square" anchor="ctr" anchorCtr="1"/>
          <a:lstStyle/>
          <a:p>
            <a:pPr>
              <a:defRPr sz="36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813469584"/>
        <c:crosses val="autoZero"/>
        <c:auto val="1"/>
        <c:lblAlgn val="ctr"/>
        <c:lblOffset val="100"/>
        <c:noMultiLvlLbl val="0"/>
      </c:catAx>
      <c:valAx>
        <c:axId val="-81346958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3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CA" sz="40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umber</a:t>
                </a:r>
                <a:r>
                  <a:rPr lang="en-CA" sz="4000" baseline="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of reads (million)</a:t>
                </a:r>
                <a:endParaRPr lang="en-CA" sz="40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0281168365180818"/>
              <c:y val="0.12690288690269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3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4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826028368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legend>
      <c:legendPos val="b"/>
      <c:layout>
        <c:manualLayout>
          <c:xMode val="edge"/>
          <c:yMode val="edge"/>
          <c:x val="0.585797969798603"/>
          <c:y val="0.0640616751035321"/>
          <c:w val="0.278820892668993"/>
          <c:h val="0.078169237904523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4000" b="0" i="0" u="none" strike="noStrike" kern="1200" baseline="0">
              <a:solidFill>
                <a:schemeClr val="tx1"/>
              </a:solidFill>
              <a:latin typeface="Times" panose="02020603050405020304" pitchFamily="18" charset="0"/>
              <a:ea typeface="+mn-ea"/>
              <a:cs typeface="Times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64647415792801"/>
          <c:y val="0.0945850507481885"/>
          <c:w val="0.921168138893603"/>
          <c:h val="0.36286930708988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33CC33"/>
            </a:solidFill>
            <a:ln>
              <a:noFill/>
            </a:ln>
            <a:effectLst/>
          </c:spPr>
          <c:invertIfNegative val="0"/>
          <c:cat>
            <c:multiLvlStrRef>
              <c:f>Shoot!$O$12:$P$41</c:f>
              <c:multiLvlStrCache>
                <c:ptCount val="30"/>
                <c:lvl>
                  <c:pt idx="0">
                    <c:v>Regulation of biological process</c:v>
                  </c:pt>
                  <c:pt idx="1">
                    <c:v>Response to stress</c:v>
                  </c:pt>
                  <c:pt idx="2">
                    <c:v>Response to stimuli and chemical </c:v>
                  </c:pt>
                  <c:pt idx="3">
                    <c:v>Response to abiotic stimulus</c:v>
                  </c:pt>
                  <c:pt idx="4">
                    <c:v>Defense response </c:v>
                  </c:pt>
                  <c:pt idx="5">
                    <c:v>Signal transduction </c:v>
                  </c:pt>
                  <c:pt idx="6">
                    <c:v>Phosphorylation </c:v>
                  </c:pt>
                  <c:pt idx="7">
                    <c:v>Response to lipid</c:v>
                  </c:pt>
                  <c:pt idx="8">
                    <c:v>Transmembrane transport</c:v>
                  </c:pt>
                  <c:pt idx="9">
                    <c:v>Resposne to ABA</c:v>
                  </c:pt>
                  <c:pt idx="10">
                    <c:v>Secondary metabolic process</c:v>
                  </c:pt>
                  <c:pt idx="11">
                    <c:v>Response to Jasmonic acid </c:v>
                  </c:pt>
                  <c:pt idx="12">
                    <c:v>Response to chitin </c:v>
                  </c:pt>
                  <c:pt idx="13">
                    <c:v>Response to Salicylic acid</c:v>
                  </c:pt>
                  <c:pt idx="14">
                    <c:v>Flavonoid metabolic process</c:v>
                  </c:pt>
                  <c:pt idx="15">
                    <c:v>Toxin catabolic process</c:v>
                  </c:pt>
                  <c:pt idx="16">
                    <c:v>Anthocyanin-containing compound metabolic process</c:v>
                  </c:pt>
                  <c:pt idx="17">
                    <c:v>Metabolic process</c:v>
                  </c:pt>
                  <c:pt idx="18">
                    <c:v>Response to stimulus</c:v>
                  </c:pt>
                  <c:pt idx="19">
                    <c:v>Cellular biogenesis </c:v>
                  </c:pt>
                  <c:pt idx="20">
                    <c:v>Response to hormone</c:v>
                  </c:pt>
                  <c:pt idx="21">
                    <c:v>Signal transduction </c:v>
                  </c:pt>
                  <c:pt idx="22">
                    <c:v>Cell wall metabolic process</c:v>
                  </c:pt>
                  <c:pt idx="23">
                    <c:v>Cell division and cell cycle </c:v>
                  </c:pt>
                  <c:pt idx="24">
                    <c:v>Photosynthesis and light reactions</c:v>
                  </c:pt>
                  <c:pt idx="25">
                    <c:v>Regulation of growth </c:v>
                  </c:pt>
                  <c:pt idx="26">
                    <c:v>DNA replication </c:v>
                  </c:pt>
                  <c:pt idx="27">
                    <c:v>Chlorophyll metabolic process</c:v>
                  </c:pt>
                  <c:pt idx="28">
                    <c:v>Heme metabolic process</c:v>
                  </c:pt>
                  <c:pt idx="29">
                    <c:v>Modification-dependent macromolecule catabolic process</c:v>
                  </c:pt>
                </c:lvl>
                <c:lvl>
                  <c:pt idx="0">
                    <c:v>Up-regulated</c:v>
                  </c:pt>
                  <c:pt idx="17">
                    <c:v>Down-regulated</c:v>
                  </c:pt>
                </c:lvl>
              </c:multiLvlStrCache>
            </c:multiLvlStrRef>
          </c:cat>
          <c:val>
            <c:numRef>
              <c:f>Shoot!$Q$12:$Q$41</c:f>
              <c:numCache>
                <c:formatCode>General</c:formatCode>
                <c:ptCount val="30"/>
                <c:pt idx="0">
                  <c:v>17.5</c:v>
                </c:pt>
                <c:pt idx="1">
                  <c:v>17.0</c:v>
                </c:pt>
                <c:pt idx="2">
                  <c:v>10.5</c:v>
                </c:pt>
                <c:pt idx="3">
                  <c:v>9.8</c:v>
                </c:pt>
                <c:pt idx="4">
                  <c:v>8.0</c:v>
                </c:pt>
                <c:pt idx="5">
                  <c:v>7.6</c:v>
                </c:pt>
                <c:pt idx="6">
                  <c:v>5.8</c:v>
                </c:pt>
                <c:pt idx="7">
                  <c:v>3.4</c:v>
                </c:pt>
                <c:pt idx="8">
                  <c:v>3.3</c:v>
                </c:pt>
                <c:pt idx="9">
                  <c:v>3.0</c:v>
                </c:pt>
                <c:pt idx="10">
                  <c:v>2.6</c:v>
                </c:pt>
                <c:pt idx="11">
                  <c:v>2.5</c:v>
                </c:pt>
                <c:pt idx="12">
                  <c:v>1.7</c:v>
                </c:pt>
                <c:pt idx="13">
                  <c:v>1.4</c:v>
                </c:pt>
                <c:pt idx="14">
                  <c:v>1.3</c:v>
                </c:pt>
                <c:pt idx="15">
                  <c:v>1.2</c:v>
                </c:pt>
                <c:pt idx="16">
                  <c:v>1.0</c:v>
                </c:pt>
                <c:pt idx="17">
                  <c:v>33.7</c:v>
                </c:pt>
                <c:pt idx="18">
                  <c:v>21.2</c:v>
                </c:pt>
                <c:pt idx="19">
                  <c:v>9.0</c:v>
                </c:pt>
                <c:pt idx="20">
                  <c:v>7.4</c:v>
                </c:pt>
                <c:pt idx="21">
                  <c:v>7.2</c:v>
                </c:pt>
                <c:pt idx="22">
                  <c:v>4.0</c:v>
                </c:pt>
                <c:pt idx="23">
                  <c:v>3.7</c:v>
                </c:pt>
                <c:pt idx="24">
                  <c:v>3.6</c:v>
                </c:pt>
                <c:pt idx="25">
                  <c:v>1.6</c:v>
                </c:pt>
                <c:pt idx="26">
                  <c:v>1.2</c:v>
                </c:pt>
                <c:pt idx="27">
                  <c:v>0.7</c:v>
                </c:pt>
                <c:pt idx="28">
                  <c:v>0.4</c:v>
                </c:pt>
                <c:pt idx="29">
                  <c:v>0.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60"/>
        <c:axId val="-813624528"/>
        <c:axId val="-813622208"/>
      </c:barChart>
      <c:catAx>
        <c:axId val="-8136245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5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813622208"/>
        <c:crosses val="autoZero"/>
        <c:auto val="1"/>
        <c:lblAlgn val="ctr"/>
        <c:lblOffset val="100"/>
        <c:noMultiLvlLbl val="0"/>
      </c:catAx>
      <c:valAx>
        <c:axId val="-81362220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28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CA"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ercentage</a:t>
                </a:r>
                <a:r>
                  <a:rPr lang="en-CA" sz="2800" baseline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of mapped genes to the term</a:t>
                </a:r>
                <a:endParaRPr lang="en-CA" sz="280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00600467593135038"/>
              <c:y val="0.024148819628505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28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8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81362452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063589576234658"/>
          <c:y val="0.0663737916906728"/>
          <c:w val="0.919705734511319"/>
          <c:h val="0.364351834069522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33CC33"/>
            </a:solidFill>
            <a:ln>
              <a:noFill/>
            </a:ln>
            <a:effectLst/>
          </c:spPr>
          <c:invertIfNegative val="0"/>
          <c:cat>
            <c:multiLvlStrRef>
              <c:f>Root!$N$24:$O$46</c:f>
              <c:multiLvlStrCache>
                <c:ptCount val="23"/>
                <c:lvl>
                  <c:pt idx="0">
                    <c:v>Response to stimulus and chemicals</c:v>
                  </c:pt>
                  <c:pt idx="1">
                    <c:v>Response to stress</c:v>
                  </c:pt>
                  <c:pt idx="2">
                    <c:v>Organic cyclic compounds metabolic process</c:v>
                  </c:pt>
                  <c:pt idx="3">
                    <c:v>Response to water depriviationa and abiotic stress</c:v>
                  </c:pt>
                  <c:pt idx="4">
                    <c:v>Lipid metabolic process</c:v>
                  </c:pt>
                  <c:pt idx="5">
                    <c:v>Transcription and translation </c:v>
                  </c:pt>
                  <c:pt idx="6">
                    <c:v>Oxidation-reduction process</c:v>
                  </c:pt>
                  <c:pt idx="7">
                    <c:v>Response to hormone</c:v>
                  </c:pt>
                  <c:pt idx="8">
                    <c:v>Transmembrane transport</c:v>
                  </c:pt>
                  <c:pt idx="9">
                    <c:v>Secondary metabolite process</c:v>
                  </c:pt>
                  <c:pt idx="10">
                    <c:v>Jasmonic acid metabolism, regulation and signalling  process</c:v>
                  </c:pt>
                  <c:pt idx="11">
                    <c:v>Oxylipin metabiolic process</c:v>
                  </c:pt>
                  <c:pt idx="12">
                    <c:v>Macromolecule modification process</c:v>
                  </c:pt>
                  <c:pt idx="13">
                    <c:v>Nitrogen compounds metabolic process</c:v>
                  </c:pt>
                  <c:pt idx="14">
                    <c:v>Macromolecule metabolic process</c:v>
                  </c:pt>
                  <c:pt idx="15">
                    <c:v>Cell wall organization </c:v>
                  </c:pt>
                  <c:pt idx="16">
                    <c:v>RNA processing and nucleobase-containing compound metabolic process</c:v>
                  </c:pt>
                  <c:pt idx="17">
                    <c:v>Gene expression </c:v>
                  </c:pt>
                  <c:pt idx="18">
                    <c:v>Translation and cellular protein metabolic process</c:v>
                  </c:pt>
                  <c:pt idx="19">
                    <c:v>Anion transport</c:v>
                  </c:pt>
                  <c:pt idx="20">
                    <c:v>Secondary metabolic process</c:v>
                  </c:pt>
                  <c:pt idx="21">
                    <c:v>Hydrogen peroxide catabolic process</c:v>
                  </c:pt>
                  <c:pt idx="22">
                    <c:v>Glucosinolate metabolic process</c:v>
                  </c:pt>
                </c:lvl>
                <c:lvl>
                  <c:pt idx="0">
                    <c:v>Up-regulated</c:v>
                  </c:pt>
                  <c:pt idx="12">
                    <c:v>Down-regulated</c:v>
                  </c:pt>
                </c:lvl>
              </c:multiLvlStrCache>
            </c:multiLvlStrRef>
          </c:cat>
          <c:val>
            <c:numRef>
              <c:f>Root!$P$24:$P$46</c:f>
              <c:numCache>
                <c:formatCode>General</c:formatCode>
                <c:ptCount val="23"/>
                <c:pt idx="0">
                  <c:v>18.0</c:v>
                </c:pt>
                <c:pt idx="1">
                  <c:v>14.5</c:v>
                </c:pt>
                <c:pt idx="2">
                  <c:v>11.2</c:v>
                </c:pt>
                <c:pt idx="3">
                  <c:v>9.6</c:v>
                </c:pt>
                <c:pt idx="4">
                  <c:v>8.700000000000001</c:v>
                </c:pt>
                <c:pt idx="5">
                  <c:v>8.3</c:v>
                </c:pt>
                <c:pt idx="6">
                  <c:v>8.0</c:v>
                </c:pt>
                <c:pt idx="7">
                  <c:v>7.6</c:v>
                </c:pt>
                <c:pt idx="8">
                  <c:v>6.5</c:v>
                </c:pt>
                <c:pt idx="9">
                  <c:v>3.7</c:v>
                </c:pt>
                <c:pt idx="10">
                  <c:v>2.0</c:v>
                </c:pt>
                <c:pt idx="11">
                  <c:v>1.3</c:v>
                </c:pt>
                <c:pt idx="12">
                  <c:v>16.7</c:v>
                </c:pt>
                <c:pt idx="13">
                  <c:v>15.7</c:v>
                </c:pt>
                <c:pt idx="14">
                  <c:v>11.0</c:v>
                </c:pt>
                <c:pt idx="15">
                  <c:v>6.7</c:v>
                </c:pt>
                <c:pt idx="16">
                  <c:v>6.5</c:v>
                </c:pt>
                <c:pt idx="17">
                  <c:v>5.6</c:v>
                </c:pt>
                <c:pt idx="18">
                  <c:v>4.5</c:v>
                </c:pt>
                <c:pt idx="19">
                  <c:v>4.0</c:v>
                </c:pt>
                <c:pt idx="20">
                  <c:v>3.8</c:v>
                </c:pt>
                <c:pt idx="21">
                  <c:v>2.4</c:v>
                </c:pt>
                <c:pt idx="22">
                  <c:v>1.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axId val="-1202785200"/>
        <c:axId val="-1202782880"/>
      </c:barChart>
      <c:catAx>
        <c:axId val="-12027852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25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1202782880"/>
        <c:crosses val="autoZero"/>
        <c:auto val="1"/>
        <c:lblAlgn val="ctr"/>
        <c:lblOffset val="100"/>
        <c:noMultiLvlLbl val="0"/>
      </c:catAx>
      <c:valAx>
        <c:axId val="-120278288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28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CA" sz="280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ercentage of genes mapped by the term</a:t>
                </a:r>
                <a:r>
                  <a:rPr lang="en-CA" sz="2800" baseline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endParaRPr lang="en-CA" sz="280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00708909511246653"/>
              <c:y val="0.00051398596287208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28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8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120278520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view3D>
      <c:rotX val="15"/>
      <c:rotY val="20"/>
      <c:depthPercent val="100"/>
      <c:rAngAx val="1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>
        <c:manualLayout>
          <c:layoutTarget val="inner"/>
          <c:xMode val="edge"/>
          <c:yMode val="edge"/>
          <c:x val="0.110276808182482"/>
          <c:y val="0.0225555555555556"/>
          <c:w val="0.845912952891198"/>
          <c:h val="0.506254009915427"/>
        </c:manualLayout>
      </c:layout>
      <c:bar3DChart>
        <c:barDir val="col"/>
        <c:grouping val="standard"/>
        <c:varyColors val="0"/>
        <c:ser>
          <c:idx val="0"/>
          <c:order val="0"/>
          <c:tx>
            <c:strRef>
              <c:f>'17 dpi'!$H$29</c:f>
              <c:strCache>
                <c:ptCount val="1"/>
                <c:pt idx="0">
                  <c:v>Up</c:v>
                </c:pt>
              </c:strCache>
            </c:strRef>
          </c:tx>
          <c:spPr>
            <a:solidFill>
              <a:srgbClr val="FF8029"/>
            </a:solidFill>
            <a:ln>
              <a:noFill/>
            </a:ln>
            <a:effectLst/>
            <a:sp3d/>
          </c:spPr>
          <c:invertIfNegative val="0"/>
          <c:cat>
            <c:strRef>
              <c:f>'17 dpi'!$E$30:$G$44</c:f>
              <c:strCache>
                <c:ptCount val="15"/>
                <c:pt idx="0">
                  <c:v>Aliphatic glucosinolate biosynthesis</c:v>
                </c:pt>
                <c:pt idx="1">
                  <c:v>CO2 fixation into oxaloacetate</c:v>
                </c:pt>
                <c:pt idx="2">
                  <c:v>Cytokinins N-glucoside biosynthesis</c:v>
                </c:pt>
                <c:pt idx="3">
                  <c:v>Gibberellin biosynthesis II </c:v>
                </c:pt>
                <c:pt idx="4">
                  <c:v>Glycolipid biosynthesis</c:v>
                </c:pt>
                <c:pt idx="5">
                  <c:v>Flavonoid biosynthesis </c:v>
                </c:pt>
                <c:pt idx="6">
                  <c:v>Siroheme biosynthesis</c:v>
                </c:pt>
                <c:pt idx="7">
                  <c:v>Luteolin biosynthesis</c:v>
                </c:pt>
                <c:pt idx="8">
                  <c:v>Myo-inositol biosynthesis</c:v>
                </c:pt>
                <c:pt idx="9">
                  <c:v>Phaseic acid biosynthesis</c:v>
                </c:pt>
                <c:pt idx="10">
                  <c:v>Serine biosynthesis</c:v>
                </c:pt>
                <c:pt idx="11">
                  <c:v>Stachyose biosynthesis</c:v>
                </c:pt>
                <c:pt idx="12">
                  <c:v>VLCFAs  biosynthesis I</c:v>
                </c:pt>
                <c:pt idx="13">
                  <c:v>Vitamin E biosynthesis (tocopherols)</c:v>
                </c:pt>
                <c:pt idx="14">
                  <c:v>Sinapate ester biosynthesis</c:v>
                </c:pt>
              </c:strCache>
            </c:strRef>
          </c:cat>
          <c:val>
            <c:numRef>
              <c:f>'17 dpi'!$H$30:$H$44</c:f>
              <c:numCache>
                <c:formatCode>General</c:formatCode>
                <c:ptCount val="15"/>
                <c:pt idx="0">
                  <c:v>1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  <c:pt idx="4">
                  <c:v>1.0</c:v>
                </c:pt>
                <c:pt idx="5">
                  <c:v>4.0</c:v>
                </c:pt>
                <c:pt idx="6">
                  <c:v>0.0</c:v>
                </c:pt>
                <c:pt idx="7">
                  <c:v>0.0</c:v>
                </c:pt>
                <c:pt idx="8">
                  <c:v>1.0</c:v>
                </c:pt>
                <c:pt idx="9">
                  <c:v>1.0</c:v>
                </c:pt>
                <c:pt idx="10">
                  <c:v>1.0</c:v>
                </c:pt>
                <c:pt idx="11">
                  <c:v>0.0</c:v>
                </c:pt>
                <c:pt idx="12">
                  <c:v>0.0</c:v>
                </c:pt>
                <c:pt idx="13">
                  <c:v>1.0</c:v>
                </c:pt>
                <c:pt idx="14">
                  <c:v>3.0</c:v>
                </c:pt>
              </c:numCache>
            </c:numRef>
          </c:val>
        </c:ser>
        <c:ser>
          <c:idx val="1"/>
          <c:order val="1"/>
          <c:tx>
            <c:strRef>
              <c:f>'17 dpi'!$I$29</c:f>
              <c:strCache>
                <c:ptCount val="1"/>
                <c:pt idx="0">
                  <c:v>Down</c:v>
                </c:pt>
              </c:strCache>
            </c:strRef>
          </c:tx>
          <c:spPr>
            <a:solidFill>
              <a:srgbClr val="599AD5"/>
            </a:solidFill>
            <a:ln>
              <a:noFill/>
            </a:ln>
            <a:effectLst/>
            <a:sp3d/>
          </c:spPr>
          <c:invertIfNegative val="0"/>
          <c:cat>
            <c:strRef>
              <c:f>'17 dpi'!$E$30:$G$44</c:f>
              <c:strCache>
                <c:ptCount val="15"/>
                <c:pt idx="0">
                  <c:v>Aliphatic glucosinolate biosynthesis</c:v>
                </c:pt>
                <c:pt idx="1">
                  <c:v>CO2 fixation into oxaloacetate</c:v>
                </c:pt>
                <c:pt idx="2">
                  <c:v>Cytokinins N-glucoside biosynthesis</c:v>
                </c:pt>
                <c:pt idx="3">
                  <c:v>Gibberellin biosynthesis II </c:v>
                </c:pt>
                <c:pt idx="4">
                  <c:v>Glycolipid biosynthesis</c:v>
                </c:pt>
                <c:pt idx="5">
                  <c:v>Flavonoid biosynthesis </c:v>
                </c:pt>
                <c:pt idx="6">
                  <c:v>Siroheme biosynthesis</c:v>
                </c:pt>
                <c:pt idx="7">
                  <c:v>Luteolin biosynthesis</c:v>
                </c:pt>
                <c:pt idx="8">
                  <c:v>Myo-inositol biosynthesis</c:v>
                </c:pt>
                <c:pt idx="9">
                  <c:v>Phaseic acid biosynthesis</c:v>
                </c:pt>
                <c:pt idx="10">
                  <c:v>Serine biosynthesis</c:v>
                </c:pt>
                <c:pt idx="11">
                  <c:v>Stachyose biosynthesis</c:v>
                </c:pt>
                <c:pt idx="12">
                  <c:v>VLCFAs  biosynthesis I</c:v>
                </c:pt>
                <c:pt idx="13">
                  <c:v>Vitamin E biosynthesis (tocopherols)</c:v>
                </c:pt>
                <c:pt idx="14">
                  <c:v>Sinapate ester biosynthesis</c:v>
                </c:pt>
              </c:strCache>
            </c:strRef>
          </c:cat>
          <c:val>
            <c:numRef>
              <c:f>'17 dpi'!$I$30:$I$44</c:f>
              <c:numCache>
                <c:formatCode>General</c:formatCode>
                <c:ptCount val="15"/>
                <c:pt idx="0">
                  <c:v>0.0</c:v>
                </c:pt>
                <c:pt idx="1">
                  <c:v>1.0</c:v>
                </c:pt>
                <c:pt idx="2">
                  <c:v>2.0</c:v>
                </c:pt>
                <c:pt idx="3">
                  <c:v>1.0</c:v>
                </c:pt>
                <c:pt idx="4">
                  <c:v>0.0</c:v>
                </c:pt>
                <c:pt idx="5">
                  <c:v>0.0</c:v>
                </c:pt>
                <c:pt idx="6">
                  <c:v>1.0</c:v>
                </c:pt>
                <c:pt idx="7">
                  <c:v>1.0</c:v>
                </c:pt>
                <c:pt idx="8">
                  <c:v>0.0</c:v>
                </c:pt>
                <c:pt idx="9">
                  <c:v>0.0</c:v>
                </c:pt>
                <c:pt idx="10">
                  <c:v>0.0</c:v>
                </c:pt>
                <c:pt idx="11">
                  <c:v>2.0</c:v>
                </c:pt>
                <c:pt idx="12">
                  <c:v>2.0</c:v>
                </c:pt>
                <c:pt idx="13">
                  <c:v>0.0</c:v>
                </c:pt>
                <c:pt idx="14">
                  <c:v>0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-728250880"/>
        <c:axId val="-825403808"/>
        <c:axId val="-1202812176"/>
      </c:bar3DChart>
      <c:catAx>
        <c:axId val="-72825088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8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825403808"/>
        <c:crosses val="autoZero"/>
        <c:auto val="1"/>
        <c:lblAlgn val="ctr"/>
        <c:lblOffset val="100"/>
        <c:noMultiLvlLbl val="0"/>
      </c:catAx>
      <c:valAx>
        <c:axId val="-825403808"/>
        <c:scaling>
          <c:orientation val="minMax"/>
        </c:scaling>
        <c:delete val="0"/>
        <c:axPos val="l"/>
        <c:majorGridlines>
          <c:spPr>
            <a:ln w="3175" cap="flat" cmpd="sng" algn="ctr">
              <a:solidFill>
                <a:schemeClr val="bg2">
                  <a:lumMod val="7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28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CA" sz="2800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umber</a:t>
                </a:r>
                <a:r>
                  <a:rPr lang="en-CA" sz="2800" b="1" baseline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of genes</a:t>
                </a:r>
                <a:endParaRPr lang="en-CA" sz="2800" b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0799639479910253"/>
              <c:y val="0.19404962563753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28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8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728250880"/>
        <c:crosses val="autoZero"/>
        <c:crossBetween val="between"/>
        <c:majorUnit val="1.0"/>
      </c:valAx>
      <c:serAx>
        <c:axId val="-1202812176"/>
        <c:scaling>
          <c:orientation val="minMax"/>
        </c:scaling>
        <c:delete val="1"/>
        <c:axPos val="b"/>
        <c:majorTickMark val="none"/>
        <c:minorTickMark val="none"/>
        <c:tickLblPos val="nextTo"/>
        <c:crossAx val="-825403808"/>
        <c:crosses val="autoZero"/>
      </c:ser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786988720438145"/>
          <c:y val="0.772476094082319"/>
          <c:w val="0.211607149889609"/>
          <c:h val="0.064957472774626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40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view3D>
      <c:rotX val="15"/>
      <c:rotY val="20"/>
      <c:depthPercent val="100"/>
      <c:rAngAx val="1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>
        <c:manualLayout>
          <c:layoutTarget val="inner"/>
          <c:xMode val="edge"/>
          <c:yMode val="edge"/>
          <c:x val="0.104556341103381"/>
          <c:y val="0.0501636429227373"/>
          <c:w val="0.838298626645699"/>
          <c:h val="0.446886747124655"/>
        </c:manualLayout>
      </c:layout>
      <c:bar3DChart>
        <c:barDir val="col"/>
        <c:grouping val="standard"/>
        <c:varyColors val="0"/>
        <c:ser>
          <c:idx val="0"/>
          <c:order val="0"/>
          <c:tx>
            <c:strRef>
              <c:f>'[Chart in Microsoft PowerPoint]17 dpi'!$G$56</c:f>
              <c:strCache>
                <c:ptCount val="1"/>
                <c:pt idx="0">
                  <c:v>Up</c:v>
                </c:pt>
              </c:strCache>
            </c:strRef>
          </c:tx>
          <c:spPr>
            <a:solidFill>
              <a:srgbClr val="FF6600"/>
            </a:solidFill>
            <a:ln>
              <a:noFill/>
            </a:ln>
            <a:effectLst/>
            <a:sp3d/>
          </c:spPr>
          <c:invertIfNegative val="0"/>
          <c:cat>
            <c:strRef>
              <c:f>'[Chart in Microsoft PowerPoint]17 dpi'!$D$57:$F$67</c:f>
              <c:strCache>
                <c:ptCount val="11"/>
                <c:pt idx="0">
                  <c:v>Abscisic Acid Biosynthesis </c:v>
                </c:pt>
                <c:pt idx="1">
                  <c:v>Ammonia assimilation cycle </c:v>
                </c:pt>
                <c:pt idx="2">
                  <c:v>Glutamate-glutamine shuttle</c:v>
                </c:pt>
                <c:pt idx="3">
                  <c:v>Gluthamine biosynthesis </c:v>
                </c:pt>
                <c:pt idx="4">
                  <c:v>Iron reduction and absorption</c:v>
                </c:pt>
                <c:pt idx="5">
                  <c:v>Leucine degradation </c:v>
                </c:pt>
                <c:pt idx="6">
                  <c:v>Leucodelphinidin biosynthesis</c:v>
                </c:pt>
                <c:pt idx="7">
                  <c:v>2-Oxoisovalerate decarboxylation </c:v>
                </c:pt>
                <c:pt idx="8">
                  <c:v>Ornithine-citrulline shuttle </c:v>
                </c:pt>
                <c:pt idx="9">
                  <c:v>Pyrimidine salvage pathway</c:v>
                </c:pt>
                <c:pt idx="10">
                  <c:v>Sinapate ester biosynthesis</c:v>
                </c:pt>
              </c:strCache>
            </c:strRef>
          </c:cat>
          <c:val>
            <c:numRef>
              <c:f>'[Chart in Microsoft PowerPoint]17 dpi'!$G$57:$G$67</c:f>
              <c:numCache>
                <c:formatCode>General</c:formatCode>
                <c:ptCount val="11"/>
                <c:pt idx="0">
                  <c:v>0.0</c:v>
                </c:pt>
                <c:pt idx="1">
                  <c:v>2.0</c:v>
                </c:pt>
                <c:pt idx="2">
                  <c:v>1.0</c:v>
                </c:pt>
                <c:pt idx="3">
                  <c:v>1.0</c:v>
                </c:pt>
                <c:pt idx="4">
                  <c:v>1.0</c:v>
                </c:pt>
                <c:pt idx="5">
                  <c:v>0.0</c:v>
                </c:pt>
                <c:pt idx="6">
                  <c:v>0.0</c:v>
                </c:pt>
                <c:pt idx="7">
                  <c:v>0.0</c:v>
                </c:pt>
                <c:pt idx="8">
                  <c:v>1.0</c:v>
                </c:pt>
                <c:pt idx="9">
                  <c:v>0.0</c:v>
                </c:pt>
                <c:pt idx="10">
                  <c:v>3.0</c:v>
                </c:pt>
              </c:numCache>
            </c:numRef>
          </c:val>
        </c:ser>
        <c:ser>
          <c:idx val="1"/>
          <c:order val="1"/>
          <c:tx>
            <c:strRef>
              <c:f>'[Chart in Microsoft PowerPoint]17 dpi'!$H$56</c:f>
              <c:strCache>
                <c:ptCount val="1"/>
                <c:pt idx="0">
                  <c:v>Down</c:v>
                </c:pt>
              </c:strCache>
            </c:strRef>
          </c:tx>
          <c:spPr>
            <a:solidFill>
              <a:srgbClr val="448DD0"/>
            </a:solidFill>
            <a:ln>
              <a:noFill/>
            </a:ln>
            <a:effectLst/>
            <a:sp3d/>
          </c:spPr>
          <c:invertIfNegative val="0"/>
          <c:cat>
            <c:strRef>
              <c:f>'[Chart in Microsoft PowerPoint]17 dpi'!$D$57:$F$67</c:f>
              <c:strCache>
                <c:ptCount val="11"/>
                <c:pt idx="0">
                  <c:v>Abscisic Acid Biosynthesis </c:v>
                </c:pt>
                <c:pt idx="1">
                  <c:v>Ammonia assimilation cycle </c:v>
                </c:pt>
                <c:pt idx="2">
                  <c:v>Glutamate-glutamine shuttle</c:v>
                </c:pt>
                <c:pt idx="3">
                  <c:v>Gluthamine biosynthesis </c:v>
                </c:pt>
                <c:pt idx="4">
                  <c:v>Iron reduction and absorption</c:v>
                </c:pt>
                <c:pt idx="5">
                  <c:v>Leucine degradation </c:v>
                </c:pt>
                <c:pt idx="6">
                  <c:v>Leucodelphinidin biosynthesis</c:v>
                </c:pt>
                <c:pt idx="7">
                  <c:v>2-Oxoisovalerate decarboxylation </c:v>
                </c:pt>
                <c:pt idx="8">
                  <c:v>Ornithine-citrulline shuttle </c:v>
                </c:pt>
                <c:pt idx="9">
                  <c:v>Pyrimidine salvage pathway</c:v>
                </c:pt>
                <c:pt idx="10">
                  <c:v>Sinapate ester biosynthesis</c:v>
                </c:pt>
              </c:strCache>
            </c:strRef>
          </c:cat>
          <c:val>
            <c:numRef>
              <c:f>'[Chart in Microsoft PowerPoint]17 dpi'!$H$57:$H$67</c:f>
              <c:numCache>
                <c:formatCode>General</c:formatCode>
                <c:ptCount val="11"/>
                <c:pt idx="0">
                  <c:v>1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  <c:pt idx="4">
                  <c:v>0.0</c:v>
                </c:pt>
                <c:pt idx="5">
                  <c:v>2.0</c:v>
                </c:pt>
                <c:pt idx="6">
                  <c:v>2.0</c:v>
                </c:pt>
                <c:pt idx="7">
                  <c:v>1.0</c:v>
                </c:pt>
                <c:pt idx="8">
                  <c:v>0.0</c:v>
                </c:pt>
                <c:pt idx="9">
                  <c:v>4.0</c:v>
                </c:pt>
                <c:pt idx="10">
                  <c:v>0.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-1203028720"/>
        <c:axId val="-813522592"/>
        <c:axId val="-1203256272"/>
      </c:bar3DChart>
      <c:catAx>
        <c:axId val="-12030287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8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813522592"/>
        <c:crosses val="autoZero"/>
        <c:auto val="1"/>
        <c:lblAlgn val="ctr"/>
        <c:lblOffset val="100"/>
        <c:noMultiLvlLbl val="0"/>
      </c:catAx>
      <c:valAx>
        <c:axId val="-813522592"/>
        <c:scaling>
          <c:orientation val="minMax"/>
        </c:scaling>
        <c:delete val="0"/>
        <c:axPos val="l"/>
        <c:majorGridlines>
          <c:spPr>
            <a:ln w="3175" cap="flat" cmpd="sng" algn="ctr">
              <a:solidFill>
                <a:schemeClr val="bg2">
                  <a:lumMod val="7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28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CA" sz="2800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umber</a:t>
                </a:r>
                <a:r>
                  <a:rPr lang="en-CA" sz="2800" b="1" baseline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of genes</a:t>
                </a:r>
                <a:endParaRPr lang="en-CA" sz="2800" b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0451399651204956"/>
              <c:y val="0.18518985126859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28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31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8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1203028720"/>
        <c:crosses val="autoZero"/>
        <c:crossBetween val="between"/>
        <c:majorUnit val="1.0"/>
      </c:valAx>
      <c:serAx>
        <c:axId val="-1203256272"/>
        <c:scaling>
          <c:orientation val="minMax"/>
        </c:scaling>
        <c:delete val="1"/>
        <c:axPos val="b"/>
        <c:majorTickMark val="none"/>
        <c:minorTickMark val="none"/>
        <c:tickLblPos val="nextTo"/>
        <c:crossAx val="-813522592"/>
        <c:crosses val="autoZero"/>
      </c:ser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view3D>
      <c:rotX val="15"/>
      <c:rotY val="20"/>
      <c:depthPercent val="100"/>
      <c:rAngAx val="1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>
        <c:manualLayout>
          <c:layoutTarget val="inner"/>
          <c:xMode val="edge"/>
          <c:yMode val="edge"/>
          <c:x val="0.046800109877948"/>
          <c:y val="0.0377228255803944"/>
          <c:w val="0.93333980236208"/>
          <c:h val="0.608857964624983"/>
        </c:manualLayout>
      </c:layout>
      <c:bar3DChart>
        <c:barDir val="col"/>
        <c:grouping val="standard"/>
        <c:varyColors val="0"/>
        <c:ser>
          <c:idx val="0"/>
          <c:order val="0"/>
          <c:tx>
            <c:strRef>
              <c:f>'[Chart in Microsoft PowerPoint]20 dpi'!$H$5</c:f>
              <c:strCache>
                <c:ptCount val="1"/>
                <c:pt idx="0">
                  <c:v>Up</c:v>
                </c:pt>
              </c:strCache>
            </c:strRef>
          </c:tx>
          <c:spPr>
            <a:solidFill>
              <a:srgbClr val="FF8633"/>
            </a:solidFill>
            <a:ln>
              <a:noFill/>
            </a:ln>
            <a:effectLst/>
            <a:sp3d/>
          </c:spPr>
          <c:invertIfNegative val="0"/>
          <c:cat>
            <c:strRef>
              <c:f>'[Chart in Microsoft PowerPoint]20 dpi'!$E$6:$G$21</c:f>
              <c:strCache>
                <c:ptCount val="16"/>
                <c:pt idx="0">
                  <c:v>Anthocyanin modification</c:v>
                </c:pt>
                <c:pt idx="1">
                  <c:v>Cellulose biosynthesis</c:v>
                </c:pt>
                <c:pt idx="2">
                  <c:v>Citrulline biosynthesis</c:v>
                </c:pt>
                <c:pt idx="3">
                  <c:v>Ethylene biosynthesis I</c:v>
                </c:pt>
                <c:pt idx="4">
                  <c:v>Flavonoid biosynthesis</c:v>
                </c:pt>
                <c:pt idx="5">
                  <c:v>Homogalacturonan degradation</c:v>
                </c:pt>
                <c:pt idx="6">
                  <c:v>Phosphate acquisition</c:v>
                </c:pt>
                <c:pt idx="7">
                  <c:v>Photosynthesis light reactions</c:v>
                </c:pt>
                <c:pt idx="8">
                  <c:v>Sinapate ester biosynthesis</c:v>
                </c:pt>
                <c:pt idx="9">
                  <c:v>Trehalose biosynthesis</c:v>
                </c:pt>
                <c:pt idx="10">
                  <c:v>VLCFAs biosynthesis</c:v>
                </c:pt>
                <c:pt idx="11">
                  <c:v>Glutathione-mediated detoxification II</c:v>
                </c:pt>
                <c:pt idx="12">
                  <c:v>Kaempferol glycoside biosynthesis</c:v>
                </c:pt>
                <c:pt idx="13">
                  <c:v>Quercetin glycoside biosynthesis</c:v>
                </c:pt>
                <c:pt idx="14">
                  <c:v>Suberin monomers biosynthesis</c:v>
                </c:pt>
                <c:pt idx="15">
                  <c:v>Triacylglycerol degradation</c:v>
                </c:pt>
              </c:strCache>
            </c:strRef>
          </c:cat>
          <c:val>
            <c:numRef>
              <c:f>'[Chart in Microsoft PowerPoint]20 dpi'!$H$6:$H$21</c:f>
              <c:numCache>
                <c:formatCode>General</c:formatCode>
                <c:ptCount val="16"/>
                <c:pt idx="0">
                  <c:v>9.0</c:v>
                </c:pt>
                <c:pt idx="1">
                  <c:v>3.0</c:v>
                </c:pt>
                <c:pt idx="2">
                  <c:v>5.0</c:v>
                </c:pt>
                <c:pt idx="3">
                  <c:v>1.0</c:v>
                </c:pt>
                <c:pt idx="4">
                  <c:v>16.0</c:v>
                </c:pt>
                <c:pt idx="5">
                  <c:v>0.0</c:v>
                </c:pt>
                <c:pt idx="6">
                  <c:v>0.0</c:v>
                </c:pt>
                <c:pt idx="7">
                  <c:v>0.0</c:v>
                </c:pt>
                <c:pt idx="8">
                  <c:v>8.0</c:v>
                </c:pt>
                <c:pt idx="9">
                  <c:v>4.0</c:v>
                </c:pt>
                <c:pt idx="10">
                  <c:v>0.0</c:v>
                </c:pt>
                <c:pt idx="11">
                  <c:v>6.0</c:v>
                </c:pt>
                <c:pt idx="12">
                  <c:v>5.0</c:v>
                </c:pt>
                <c:pt idx="13">
                  <c:v>12.0</c:v>
                </c:pt>
                <c:pt idx="14">
                  <c:v>8.0</c:v>
                </c:pt>
                <c:pt idx="15">
                  <c:v>1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D960-4949-8A1E-DDCFC11754BE}"/>
            </c:ext>
          </c:extLst>
        </c:ser>
        <c:ser>
          <c:idx val="1"/>
          <c:order val="1"/>
          <c:tx>
            <c:strRef>
              <c:f>'[Chart in Microsoft PowerPoint]20 dpi'!$I$5</c:f>
              <c:strCache>
                <c:ptCount val="1"/>
                <c:pt idx="0">
                  <c:v>Down</c:v>
                </c:pt>
              </c:strCache>
            </c:strRef>
          </c:tx>
          <c:spPr>
            <a:solidFill>
              <a:srgbClr val="599AD5"/>
            </a:solidFill>
            <a:ln>
              <a:noFill/>
            </a:ln>
            <a:effectLst/>
            <a:sp3d/>
          </c:spPr>
          <c:invertIfNegative val="0"/>
          <c:cat>
            <c:strRef>
              <c:f>'[Chart in Microsoft PowerPoint]20 dpi'!$E$6:$G$21</c:f>
              <c:strCache>
                <c:ptCount val="16"/>
                <c:pt idx="0">
                  <c:v>Anthocyanin modification</c:v>
                </c:pt>
                <c:pt idx="1">
                  <c:v>Cellulose biosynthesis</c:v>
                </c:pt>
                <c:pt idx="2">
                  <c:v>Citrulline biosynthesis</c:v>
                </c:pt>
                <c:pt idx="3">
                  <c:v>Ethylene biosynthesis I</c:v>
                </c:pt>
                <c:pt idx="4">
                  <c:v>Flavonoid biosynthesis</c:v>
                </c:pt>
                <c:pt idx="5">
                  <c:v>Homogalacturonan degradation</c:v>
                </c:pt>
                <c:pt idx="6">
                  <c:v>Phosphate acquisition</c:v>
                </c:pt>
                <c:pt idx="7">
                  <c:v>Photosynthesis light reactions</c:v>
                </c:pt>
                <c:pt idx="8">
                  <c:v>Sinapate ester biosynthesis</c:v>
                </c:pt>
                <c:pt idx="9">
                  <c:v>Trehalose biosynthesis</c:v>
                </c:pt>
                <c:pt idx="10">
                  <c:v>VLCFAs biosynthesis</c:v>
                </c:pt>
                <c:pt idx="11">
                  <c:v>Glutathione-mediated detoxification II</c:v>
                </c:pt>
                <c:pt idx="12">
                  <c:v>Kaempferol glycoside biosynthesis</c:v>
                </c:pt>
                <c:pt idx="13">
                  <c:v>Quercetin glycoside biosynthesis</c:v>
                </c:pt>
                <c:pt idx="14">
                  <c:v>Suberin monomers biosynthesis</c:v>
                </c:pt>
                <c:pt idx="15">
                  <c:v>Triacylglycerol degradation</c:v>
                </c:pt>
              </c:strCache>
            </c:strRef>
          </c:cat>
          <c:val>
            <c:numRef>
              <c:f>'[Chart in Microsoft PowerPoint]20 dpi'!$I$6:$I$21</c:f>
              <c:numCache>
                <c:formatCode>General</c:formatCode>
                <c:ptCount val="16"/>
                <c:pt idx="0">
                  <c:v>2.0</c:v>
                </c:pt>
                <c:pt idx="1">
                  <c:v>5.0</c:v>
                </c:pt>
                <c:pt idx="2">
                  <c:v>3.0</c:v>
                </c:pt>
                <c:pt idx="3">
                  <c:v>6.0</c:v>
                </c:pt>
                <c:pt idx="4">
                  <c:v>5.0</c:v>
                </c:pt>
                <c:pt idx="5">
                  <c:v>8.0</c:v>
                </c:pt>
                <c:pt idx="6">
                  <c:v>7.0</c:v>
                </c:pt>
                <c:pt idx="7">
                  <c:v>21.0</c:v>
                </c:pt>
                <c:pt idx="8">
                  <c:v>2.0</c:v>
                </c:pt>
                <c:pt idx="9">
                  <c:v>5.0</c:v>
                </c:pt>
                <c:pt idx="10">
                  <c:v>10.0</c:v>
                </c:pt>
                <c:pt idx="11">
                  <c:v>2.0</c:v>
                </c:pt>
                <c:pt idx="12">
                  <c:v>2.0</c:v>
                </c:pt>
                <c:pt idx="13">
                  <c:v>4.0</c:v>
                </c:pt>
                <c:pt idx="14">
                  <c:v>5.0</c:v>
                </c:pt>
                <c:pt idx="15">
                  <c:v>13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D960-4949-8A1E-DDCFC11754B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-806806208"/>
        <c:axId val="-806804432"/>
        <c:axId val="-806787328"/>
      </c:bar3DChart>
      <c:catAx>
        <c:axId val="-8068062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8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806804432"/>
        <c:crosses val="autoZero"/>
        <c:auto val="1"/>
        <c:lblAlgn val="ctr"/>
        <c:lblOffset val="100"/>
        <c:noMultiLvlLbl val="0"/>
      </c:catAx>
      <c:valAx>
        <c:axId val="-80680443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28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CA" sz="2800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umber</a:t>
                </a:r>
                <a:r>
                  <a:rPr lang="en-CA" sz="2800" b="1" baseline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of genes</a:t>
                </a:r>
                <a:endParaRPr lang="en-CA" sz="2800" b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0285714563090459"/>
              <c:y val="0.18188760814989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28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31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800" b="0" i="0" u="none" strike="noStrike" kern="1200" baseline="0">
                <a:solidFill>
                  <a:schemeClr val="tx1"/>
                </a:solidFill>
                <a:latin typeface="Times" panose="02020603050405020304" pitchFamily="18" charset="0"/>
                <a:ea typeface="+mn-ea"/>
                <a:cs typeface="Times" panose="02020603050405020304" pitchFamily="18" charset="0"/>
              </a:defRPr>
            </a:pPr>
            <a:endParaRPr lang="en-US"/>
          </a:p>
        </c:txPr>
        <c:crossAx val="-806806208"/>
        <c:crosses val="autoZero"/>
        <c:crossBetween val="between"/>
      </c:valAx>
      <c:serAx>
        <c:axId val="-806787328"/>
        <c:scaling>
          <c:orientation val="minMax"/>
        </c:scaling>
        <c:delete val="1"/>
        <c:axPos val="b"/>
        <c:majorTickMark val="none"/>
        <c:minorTickMark val="none"/>
        <c:tickLblPos val="nextTo"/>
        <c:crossAx val="-806804432"/>
        <c:crosses val="autoZero"/>
      </c:ser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75331374379521"/>
          <c:y val="0.90251991098946"/>
          <c:w val="0.197320879019886"/>
          <c:h val="0.069018719411540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40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view3D>
      <c:rotX val="15"/>
      <c:rotY val="20"/>
      <c:depthPercent val="100"/>
      <c:rAngAx val="1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>
        <c:manualLayout>
          <c:layoutTarget val="inner"/>
          <c:xMode val="edge"/>
          <c:yMode val="edge"/>
          <c:x val="0.133201235821553"/>
          <c:y val="0.0754608555863613"/>
          <c:w val="0.86081387223164"/>
          <c:h val="0.472111409328081"/>
        </c:manualLayout>
      </c:layout>
      <c:bar3DChart>
        <c:barDir val="col"/>
        <c:grouping val="standard"/>
        <c:varyColors val="0"/>
        <c:ser>
          <c:idx val="0"/>
          <c:order val="0"/>
          <c:tx>
            <c:strRef>
              <c:f>'[Chart in Microsoft PowerPoint]20 dpi'!$H$32</c:f>
              <c:strCache>
                <c:ptCount val="1"/>
                <c:pt idx="0">
                  <c:v>Up</c:v>
                </c:pt>
              </c:strCache>
            </c:strRef>
          </c:tx>
          <c:spPr>
            <a:solidFill>
              <a:srgbClr val="FF6600"/>
            </a:solidFill>
            <a:ln>
              <a:noFill/>
            </a:ln>
            <a:effectLst/>
            <a:sp3d/>
          </c:spPr>
          <c:invertIfNegative val="0"/>
          <c:cat>
            <c:strRef>
              <c:f>'[Chart in Microsoft PowerPoint]20 dpi'!$E$33:$G$45</c:f>
              <c:strCache>
                <c:ptCount val="13"/>
                <c:pt idx="0">
                  <c:v>Ammonia assimilation cycle I</c:v>
                </c:pt>
                <c:pt idx="1">
                  <c:v>Glucosinolate biosynthesis</c:v>
                </c:pt>
                <c:pt idx="2">
                  <c:v>Glutamate-glutamine shuttle</c:v>
                </c:pt>
                <c:pt idx="3">
                  <c:v>Glutamine biosynthesis III</c:v>
                </c:pt>
                <c:pt idx="4">
                  <c:v>Phenylpropanoid biosynthesis</c:v>
                </c:pt>
                <c:pt idx="5">
                  <c:v>Phospholipase</c:v>
                </c:pt>
                <c:pt idx="6">
                  <c:v>Stachyose biosynthesis</c:v>
                </c:pt>
                <c:pt idx="7">
                  <c:v>Thalianol and derivatives biosynthesis</c:v>
                </c:pt>
                <c:pt idx="8">
                  <c:v>Glutathione-mediated detoxification II</c:v>
                </c:pt>
                <c:pt idx="9">
                  <c:v>Kaempferol glycoside biosynthesis</c:v>
                </c:pt>
                <c:pt idx="10">
                  <c:v>Quercetin glycoside biosynthesis</c:v>
                </c:pt>
                <c:pt idx="11">
                  <c:v>Suberin monomers biosynthesis</c:v>
                </c:pt>
                <c:pt idx="12">
                  <c:v>Triacylglycerol degradation</c:v>
                </c:pt>
              </c:strCache>
            </c:strRef>
          </c:cat>
          <c:val>
            <c:numRef>
              <c:f>'[Chart in Microsoft PowerPoint]20 dpi'!$H$33:$H$45</c:f>
              <c:numCache>
                <c:formatCode>General</c:formatCode>
                <c:ptCount val="13"/>
                <c:pt idx="0">
                  <c:v>5.0</c:v>
                </c:pt>
                <c:pt idx="1">
                  <c:v>1.0</c:v>
                </c:pt>
                <c:pt idx="2">
                  <c:v>5.0</c:v>
                </c:pt>
                <c:pt idx="3">
                  <c:v>6.0</c:v>
                </c:pt>
                <c:pt idx="4">
                  <c:v>5.0</c:v>
                </c:pt>
                <c:pt idx="5">
                  <c:v>3.0</c:v>
                </c:pt>
                <c:pt idx="6">
                  <c:v>5.0</c:v>
                </c:pt>
                <c:pt idx="7">
                  <c:v>7.0</c:v>
                </c:pt>
                <c:pt idx="8">
                  <c:v>7.0</c:v>
                </c:pt>
                <c:pt idx="9">
                  <c:v>0.0</c:v>
                </c:pt>
                <c:pt idx="10">
                  <c:v>4.0</c:v>
                </c:pt>
                <c:pt idx="11">
                  <c:v>8.0</c:v>
                </c:pt>
                <c:pt idx="12">
                  <c:v>5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EEAE-4DC8-B795-FE67C03180F9}"/>
            </c:ext>
          </c:extLst>
        </c:ser>
        <c:ser>
          <c:idx val="1"/>
          <c:order val="1"/>
          <c:tx>
            <c:strRef>
              <c:f>'[Chart in Microsoft PowerPoint]20 dpi'!$I$32</c:f>
              <c:strCache>
                <c:ptCount val="1"/>
                <c:pt idx="0">
                  <c:v>Down</c:v>
                </c:pt>
              </c:strCache>
            </c:strRef>
          </c:tx>
          <c:spPr>
            <a:solidFill>
              <a:srgbClr val="448DD0"/>
            </a:solidFill>
            <a:ln>
              <a:noFill/>
            </a:ln>
            <a:effectLst/>
            <a:sp3d/>
          </c:spPr>
          <c:invertIfNegative val="0"/>
          <c:cat>
            <c:strRef>
              <c:f>'[Chart in Microsoft PowerPoint]20 dpi'!$E$33:$G$45</c:f>
              <c:strCache>
                <c:ptCount val="13"/>
                <c:pt idx="0">
                  <c:v>Ammonia assimilation cycle I</c:v>
                </c:pt>
                <c:pt idx="1">
                  <c:v>Glucosinolate biosynthesis</c:v>
                </c:pt>
                <c:pt idx="2">
                  <c:v>Glutamate-glutamine shuttle</c:v>
                </c:pt>
                <c:pt idx="3">
                  <c:v>Glutamine biosynthesis III</c:v>
                </c:pt>
                <c:pt idx="4">
                  <c:v>Phenylpropanoid biosynthesis</c:v>
                </c:pt>
                <c:pt idx="5">
                  <c:v>Phospholipase</c:v>
                </c:pt>
                <c:pt idx="6">
                  <c:v>Stachyose biosynthesis</c:v>
                </c:pt>
                <c:pt idx="7">
                  <c:v>Thalianol and derivatives biosynthesis</c:v>
                </c:pt>
                <c:pt idx="8">
                  <c:v>Glutathione-mediated detoxification II</c:v>
                </c:pt>
                <c:pt idx="9">
                  <c:v>Kaempferol glycoside biosynthesis</c:v>
                </c:pt>
                <c:pt idx="10">
                  <c:v>Quercetin glycoside biosynthesis</c:v>
                </c:pt>
                <c:pt idx="11">
                  <c:v>Suberin monomers biosynthesis</c:v>
                </c:pt>
                <c:pt idx="12">
                  <c:v>Triacylglycerol degradation</c:v>
                </c:pt>
              </c:strCache>
            </c:strRef>
          </c:cat>
          <c:val>
            <c:numRef>
              <c:f>'[Chart in Microsoft PowerPoint]20 dpi'!$I$33:$I$45</c:f>
              <c:numCache>
                <c:formatCode>General</c:formatCode>
                <c:ptCount val="13"/>
                <c:pt idx="0">
                  <c:v>0.0</c:v>
                </c:pt>
                <c:pt idx="1">
                  <c:v>4.0</c:v>
                </c:pt>
                <c:pt idx="2">
                  <c:v>0.0</c:v>
                </c:pt>
                <c:pt idx="3">
                  <c:v>0.0</c:v>
                </c:pt>
                <c:pt idx="4">
                  <c:v>0.0</c:v>
                </c:pt>
                <c:pt idx="5">
                  <c:v>3.0</c:v>
                </c:pt>
                <c:pt idx="6">
                  <c:v>0.0</c:v>
                </c:pt>
                <c:pt idx="7">
                  <c:v>1.0</c:v>
                </c:pt>
                <c:pt idx="8">
                  <c:v>0.0</c:v>
                </c:pt>
                <c:pt idx="9">
                  <c:v>5.0</c:v>
                </c:pt>
                <c:pt idx="10">
                  <c:v>7.0</c:v>
                </c:pt>
                <c:pt idx="11">
                  <c:v>0.0</c:v>
                </c:pt>
                <c:pt idx="12">
                  <c:v>3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EEAE-4DC8-B795-FE67C03180F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shape val="box"/>
        <c:axId val="-806831136"/>
        <c:axId val="-806829360"/>
        <c:axId val="-806827168"/>
      </c:bar3DChart>
      <c:catAx>
        <c:axId val="-8068311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8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806829360"/>
        <c:crosses val="autoZero"/>
        <c:auto val="1"/>
        <c:lblAlgn val="ctr"/>
        <c:lblOffset val="100"/>
        <c:noMultiLvlLbl val="0"/>
      </c:catAx>
      <c:valAx>
        <c:axId val="-80682936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28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CA" sz="2800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umber</a:t>
                </a:r>
                <a:r>
                  <a:rPr lang="en-CA" sz="2800" b="1" baseline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of genes</a:t>
                </a:r>
                <a:endParaRPr lang="en-CA" sz="2800" b="1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0.0759873314082132"/>
              <c:y val="0.20332064246674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28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31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8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806831136"/>
        <c:crosses val="autoZero"/>
        <c:crossBetween val="between"/>
        <c:majorUnit val="2.0"/>
      </c:valAx>
      <c:serAx>
        <c:axId val="-806827168"/>
        <c:scaling>
          <c:orientation val="minMax"/>
        </c:scaling>
        <c:delete val="1"/>
        <c:axPos val="b"/>
        <c:majorTickMark val="none"/>
        <c:minorTickMark val="none"/>
        <c:tickLblPos val="nextTo"/>
        <c:crossAx val="-806829360"/>
        <c:crosses val="autoZero"/>
      </c:ser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8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8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8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8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79484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50BEA41-3FF0-4593-8BA0-3A5AA6245F61}" type="datetimeFigureOut">
              <a:rPr lang="en-CA" smtClean="0"/>
              <a:t>2017-10-16</a:t>
            </a:fld>
            <a:endParaRPr lang="en-C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414713" y="857250"/>
            <a:ext cx="2314575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C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300412"/>
            <a:ext cx="7315200" cy="2700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79484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E62C480-B952-4AB6-AD9F-D51229BFF09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321001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2332712" rtl="0" eaLnBrk="1" latinLnBrk="0" hangingPunct="1">
      <a:defRPr sz="3061" kern="1200">
        <a:solidFill>
          <a:schemeClr val="tx1"/>
        </a:solidFill>
        <a:latin typeface="+mn-lt"/>
        <a:ea typeface="+mn-ea"/>
        <a:cs typeface="+mn-cs"/>
      </a:defRPr>
    </a:lvl1pPr>
    <a:lvl2pPr marL="1166356" algn="l" defTabSz="2332712" rtl="0" eaLnBrk="1" latinLnBrk="0" hangingPunct="1">
      <a:defRPr sz="3061" kern="1200">
        <a:solidFill>
          <a:schemeClr val="tx1"/>
        </a:solidFill>
        <a:latin typeface="+mn-lt"/>
        <a:ea typeface="+mn-ea"/>
        <a:cs typeface="+mn-cs"/>
      </a:defRPr>
    </a:lvl2pPr>
    <a:lvl3pPr marL="2332712" algn="l" defTabSz="2332712" rtl="0" eaLnBrk="1" latinLnBrk="0" hangingPunct="1">
      <a:defRPr sz="3061" kern="1200">
        <a:solidFill>
          <a:schemeClr val="tx1"/>
        </a:solidFill>
        <a:latin typeface="+mn-lt"/>
        <a:ea typeface="+mn-ea"/>
        <a:cs typeface="+mn-cs"/>
      </a:defRPr>
    </a:lvl3pPr>
    <a:lvl4pPr marL="3499070" algn="l" defTabSz="2332712" rtl="0" eaLnBrk="1" latinLnBrk="0" hangingPunct="1">
      <a:defRPr sz="3061" kern="1200">
        <a:solidFill>
          <a:schemeClr val="tx1"/>
        </a:solidFill>
        <a:latin typeface="+mn-lt"/>
        <a:ea typeface="+mn-ea"/>
        <a:cs typeface="+mn-cs"/>
      </a:defRPr>
    </a:lvl4pPr>
    <a:lvl5pPr marL="4665426" algn="l" defTabSz="2332712" rtl="0" eaLnBrk="1" latinLnBrk="0" hangingPunct="1">
      <a:defRPr sz="3061" kern="1200">
        <a:solidFill>
          <a:schemeClr val="tx1"/>
        </a:solidFill>
        <a:latin typeface="+mn-lt"/>
        <a:ea typeface="+mn-ea"/>
        <a:cs typeface="+mn-cs"/>
      </a:defRPr>
    </a:lvl5pPr>
    <a:lvl6pPr marL="5831782" algn="l" defTabSz="2332712" rtl="0" eaLnBrk="1" latinLnBrk="0" hangingPunct="1">
      <a:defRPr sz="3061" kern="1200">
        <a:solidFill>
          <a:schemeClr val="tx1"/>
        </a:solidFill>
        <a:latin typeface="+mn-lt"/>
        <a:ea typeface="+mn-ea"/>
        <a:cs typeface="+mn-cs"/>
      </a:defRPr>
    </a:lvl6pPr>
    <a:lvl7pPr marL="6998138" algn="l" defTabSz="2332712" rtl="0" eaLnBrk="1" latinLnBrk="0" hangingPunct="1">
      <a:defRPr sz="3061" kern="1200">
        <a:solidFill>
          <a:schemeClr val="tx1"/>
        </a:solidFill>
        <a:latin typeface="+mn-lt"/>
        <a:ea typeface="+mn-ea"/>
        <a:cs typeface="+mn-cs"/>
      </a:defRPr>
    </a:lvl7pPr>
    <a:lvl8pPr marL="8164496" algn="l" defTabSz="2332712" rtl="0" eaLnBrk="1" latinLnBrk="0" hangingPunct="1">
      <a:defRPr sz="3061" kern="1200">
        <a:solidFill>
          <a:schemeClr val="tx1"/>
        </a:solidFill>
        <a:latin typeface="+mn-lt"/>
        <a:ea typeface="+mn-ea"/>
        <a:cs typeface="+mn-cs"/>
      </a:defRPr>
    </a:lvl8pPr>
    <a:lvl9pPr marL="9330852" algn="l" defTabSz="2332712" rtl="0" eaLnBrk="1" latinLnBrk="0" hangingPunct="1">
      <a:defRPr sz="3061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3.xml"/></Relationships>
</file>

<file path=ppt/notesSlides/_rels/notesSlide4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5.xml"/></Relationships>
</file>

<file path=ppt/notesSlides/_rels/notesSlide5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6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414713" y="857250"/>
            <a:ext cx="2314575" cy="231457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CA" sz="1400" dirty="0">
              <a:solidFill>
                <a:schemeClr val="tx1"/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E62C480-B952-4AB6-AD9F-D51229BFF092}" type="slidenum">
              <a:rPr lang="en-CA" smtClean="0"/>
              <a:t>1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3597472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414713" y="857250"/>
            <a:ext cx="2314575" cy="231457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E62C480-B952-4AB6-AD9F-D51229BFF092}" type="slidenum">
              <a:rPr lang="en-CA" smtClean="0"/>
              <a:t>2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22741918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414713" y="857250"/>
            <a:ext cx="2314575" cy="231457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E62C480-B952-4AB6-AD9F-D51229BFF092}" type="slidenum">
              <a:rPr lang="en-CA" smtClean="0"/>
              <a:t>3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75779531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414713" y="857250"/>
            <a:ext cx="2314575" cy="231457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E62C480-B952-4AB6-AD9F-D51229BFF092}" type="slidenum">
              <a:rPr lang="en-CA" smtClean="0"/>
              <a:t>5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114755501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3414713" y="857250"/>
            <a:ext cx="2314575" cy="231457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CA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E62C480-B952-4AB6-AD9F-D51229BFF092}" type="slidenum">
              <a:rPr lang="en-CA" smtClean="0"/>
              <a:t>6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5753282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160032" y="4713405"/>
            <a:ext cx="24480361" cy="10026815"/>
          </a:xfrm>
        </p:spPr>
        <p:txBody>
          <a:bodyPr anchor="b"/>
          <a:lstStyle>
            <a:lvl1pPr algn="ctr">
              <a:defRPr sz="18898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600053" y="15126892"/>
            <a:ext cx="21600319" cy="6953434"/>
          </a:xfrm>
        </p:spPr>
        <p:txBody>
          <a:bodyPr/>
          <a:lstStyle>
            <a:lvl1pPr marL="0" indent="0" algn="ctr">
              <a:buNone/>
              <a:defRPr sz="7559"/>
            </a:lvl1pPr>
            <a:lvl2pPr marL="1440043" indent="0" algn="ctr">
              <a:buNone/>
              <a:defRPr sz="6299"/>
            </a:lvl2pPr>
            <a:lvl3pPr marL="2880086" indent="0" algn="ctr">
              <a:buNone/>
              <a:defRPr sz="5669"/>
            </a:lvl3pPr>
            <a:lvl4pPr marL="4320129" indent="0" algn="ctr">
              <a:buNone/>
              <a:defRPr sz="5040"/>
            </a:lvl4pPr>
            <a:lvl5pPr marL="5760171" indent="0" algn="ctr">
              <a:buNone/>
              <a:defRPr sz="5040"/>
            </a:lvl5pPr>
            <a:lvl6pPr marL="7200214" indent="0" algn="ctr">
              <a:buNone/>
              <a:defRPr sz="5040"/>
            </a:lvl6pPr>
            <a:lvl7pPr marL="8640257" indent="0" algn="ctr">
              <a:buNone/>
              <a:defRPr sz="5040"/>
            </a:lvl7pPr>
            <a:lvl8pPr marL="10080300" indent="0" algn="ctr">
              <a:buNone/>
              <a:defRPr sz="5040"/>
            </a:lvl8pPr>
            <a:lvl9pPr marL="11520343" indent="0" algn="ctr">
              <a:buNone/>
              <a:defRPr sz="504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6F755-54B9-40FD-9AD7-93FB76274424}" type="datetimeFigureOut">
              <a:rPr lang="en-CA" smtClean="0"/>
              <a:t>2017-10-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509B0-5F7A-46A0-A12E-40FDBD35201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0814998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6F755-54B9-40FD-9AD7-93FB76274424}" type="datetimeFigureOut">
              <a:rPr lang="en-CA" smtClean="0"/>
              <a:t>2017-10-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509B0-5F7A-46A0-A12E-40FDBD35201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5966584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0610306" y="1533356"/>
            <a:ext cx="6210092" cy="2440702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980031" y="1533356"/>
            <a:ext cx="18270270" cy="24407029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6F755-54B9-40FD-9AD7-93FB76274424}" type="datetimeFigureOut">
              <a:rPr lang="en-CA" smtClean="0"/>
              <a:t>2017-10-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509B0-5F7A-46A0-A12E-40FDBD35201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0397706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6F755-54B9-40FD-9AD7-93FB76274424}" type="datetimeFigureOut">
              <a:rPr lang="en-CA" smtClean="0"/>
              <a:t>2017-10-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509B0-5F7A-46A0-A12E-40FDBD35201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281578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65030" y="7180114"/>
            <a:ext cx="24840367" cy="11980175"/>
          </a:xfrm>
        </p:spPr>
        <p:txBody>
          <a:bodyPr anchor="b"/>
          <a:lstStyle>
            <a:lvl1pPr>
              <a:defRPr sz="18898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965030" y="19273626"/>
            <a:ext cx="24840367" cy="6300091"/>
          </a:xfrm>
        </p:spPr>
        <p:txBody>
          <a:bodyPr/>
          <a:lstStyle>
            <a:lvl1pPr marL="0" indent="0">
              <a:buNone/>
              <a:defRPr sz="7559">
                <a:solidFill>
                  <a:schemeClr val="tx1"/>
                </a:solidFill>
              </a:defRPr>
            </a:lvl1pPr>
            <a:lvl2pPr marL="1440043" indent="0">
              <a:buNone/>
              <a:defRPr sz="6299">
                <a:solidFill>
                  <a:schemeClr val="tx1">
                    <a:tint val="75000"/>
                  </a:schemeClr>
                </a:solidFill>
              </a:defRPr>
            </a:lvl2pPr>
            <a:lvl3pPr marL="2880086" indent="0">
              <a:buNone/>
              <a:defRPr sz="5669">
                <a:solidFill>
                  <a:schemeClr val="tx1">
                    <a:tint val="75000"/>
                  </a:schemeClr>
                </a:solidFill>
              </a:defRPr>
            </a:lvl3pPr>
            <a:lvl4pPr marL="4320129" indent="0">
              <a:buNone/>
              <a:defRPr sz="5040">
                <a:solidFill>
                  <a:schemeClr val="tx1">
                    <a:tint val="75000"/>
                  </a:schemeClr>
                </a:solidFill>
              </a:defRPr>
            </a:lvl4pPr>
            <a:lvl5pPr marL="5760171" indent="0">
              <a:buNone/>
              <a:defRPr sz="5040">
                <a:solidFill>
                  <a:schemeClr val="tx1">
                    <a:tint val="75000"/>
                  </a:schemeClr>
                </a:solidFill>
              </a:defRPr>
            </a:lvl5pPr>
            <a:lvl6pPr marL="7200214" indent="0">
              <a:buNone/>
              <a:defRPr sz="5040">
                <a:solidFill>
                  <a:schemeClr val="tx1">
                    <a:tint val="75000"/>
                  </a:schemeClr>
                </a:solidFill>
              </a:defRPr>
            </a:lvl6pPr>
            <a:lvl7pPr marL="8640257" indent="0">
              <a:buNone/>
              <a:defRPr sz="5040">
                <a:solidFill>
                  <a:schemeClr val="tx1">
                    <a:tint val="75000"/>
                  </a:schemeClr>
                </a:solidFill>
              </a:defRPr>
            </a:lvl7pPr>
            <a:lvl8pPr marL="10080300" indent="0">
              <a:buNone/>
              <a:defRPr sz="5040">
                <a:solidFill>
                  <a:schemeClr val="tx1">
                    <a:tint val="75000"/>
                  </a:schemeClr>
                </a:solidFill>
              </a:defRPr>
            </a:lvl8pPr>
            <a:lvl9pPr marL="11520343" indent="0">
              <a:buNone/>
              <a:defRPr sz="504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6F755-54B9-40FD-9AD7-93FB76274424}" type="datetimeFigureOut">
              <a:rPr lang="en-CA" smtClean="0"/>
              <a:t>2017-10-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509B0-5F7A-46A0-A12E-40FDBD35201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226851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980029" y="7666780"/>
            <a:ext cx="12240181" cy="18273605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4580215" y="7666780"/>
            <a:ext cx="12240181" cy="18273605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6F755-54B9-40FD-9AD7-93FB76274424}" type="datetimeFigureOut">
              <a:rPr lang="en-CA" smtClean="0"/>
              <a:t>2017-10-16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509B0-5F7A-46A0-A12E-40FDBD35201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258422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83780" y="1533362"/>
            <a:ext cx="24840367" cy="5566751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983784" y="7060106"/>
            <a:ext cx="12183928" cy="3460049"/>
          </a:xfrm>
        </p:spPr>
        <p:txBody>
          <a:bodyPr anchor="b"/>
          <a:lstStyle>
            <a:lvl1pPr marL="0" indent="0">
              <a:buNone/>
              <a:defRPr sz="7559" b="1"/>
            </a:lvl1pPr>
            <a:lvl2pPr marL="1440043" indent="0">
              <a:buNone/>
              <a:defRPr sz="6299" b="1"/>
            </a:lvl2pPr>
            <a:lvl3pPr marL="2880086" indent="0">
              <a:buNone/>
              <a:defRPr sz="5669" b="1"/>
            </a:lvl3pPr>
            <a:lvl4pPr marL="4320129" indent="0">
              <a:buNone/>
              <a:defRPr sz="5040" b="1"/>
            </a:lvl4pPr>
            <a:lvl5pPr marL="5760171" indent="0">
              <a:buNone/>
              <a:defRPr sz="5040" b="1"/>
            </a:lvl5pPr>
            <a:lvl6pPr marL="7200214" indent="0">
              <a:buNone/>
              <a:defRPr sz="5040" b="1"/>
            </a:lvl6pPr>
            <a:lvl7pPr marL="8640257" indent="0">
              <a:buNone/>
              <a:defRPr sz="5040" b="1"/>
            </a:lvl7pPr>
            <a:lvl8pPr marL="10080300" indent="0">
              <a:buNone/>
              <a:defRPr sz="5040" b="1"/>
            </a:lvl8pPr>
            <a:lvl9pPr marL="11520343" indent="0">
              <a:buNone/>
              <a:defRPr sz="504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983784" y="10520155"/>
            <a:ext cx="12183928" cy="1547356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4580217" y="7060106"/>
            <a:ext cx="12243932" cy="3460049"/>
          </a:xfrm>
        </p:spPr>
        <p:txBody>
          <a:bodyPr anchor="b"/>
          <a:lstStyle>
            <a:lvl1pPr marL="0" indent="0">
              <a:buNone/>
              <a:defRPr sz="7559" b="1"/>
            </a:lvl1pPr>
            <a:lvl2pPr marL="1440043" indent="0">
              <a:buNone/>
              <a:defRPr sz="6299" b="1"/>
            </a:lvl2pPr>
            <a:lvl3pPr marL="2880086" indent="0">
              <a:buNone/>
              <a:defRPr sz="5669" b="1"/>
            </a:lvl3pPr>
            <a:lvl4pPr marL="4320129" indent="0">
              <a:buNone/>
              <a:defRPr sz="5040" b="1"/>
            </a:lvl4pPr>
            <a:lvl5pPr marL="5760171" indent="0">
              <a:buNone/>
              <a:defRPr sz="5040" b="1"/>
            </a:lvl5pPr>
            <a:lvl6pPr marL="7200214" indent="0">
              <a:buNone/>
              <a:defRPr sz="5040" b="1"/>
            </a:lvl6pPr>
            <a:lvl7pPr marL="8640257" indent="0">
              <a:buNone/>
              <a:defRPr sz="5040" b="1"/>
            </a:lvl7pPr>
            <a:lvl8pPr marL="10080300" indent="0">
              <a:buNone/>
              <a:defRPr sz="5040" b="1"/>
            </a:lvl8pPr>
            <a:lvl9pPr marL="11520343" indent="0">
              <a:buNone/>
              <a:defRPr sz="504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4580217" y="10520155"/>
            <a:ext cx="12243932" cy="15473564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6F755-54B9-40FD-9AD7-93FB76274424}" type="datetimeFigureOut">
              <a:rPr lang="en-CA" smtClean="0"/>
              <a:t>2017-10-16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509B0-5F7A-46A0-A12E-40FDBD35201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463793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6F755-54B9-40FD-9AD7-93FB76274424}" type="datetimeFigureOut">
              <a:rPr lang="en-CA" smtClean="0"/>
              <a:t>2017-10-16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509B0-5F7A-46A0-A12E-40FDBD35201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2153694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6F755-54B9-40FD-9AD7-93FB76274424}" type="datetimeFigureOut">
              <a:rPr lang="en-CA" smtClean="0"/>
              <a:t>2017-10-16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509B0-5F7A-46A0-A12E-40FDBD35201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1544954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83780" y="1920028"/>
            <a:ext cx="9288887" cy="6720099"/>
          </a:xfrm>
        </p:spPr>
        <p:txBody>
          <a:bodyPr anchor="b"/>
          <a:lstStyle>
            <a:lvl1pPr>
              <a:defRPr sz="10079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2243932" y="4146734"/>
            <a:ext cx="14580215" cy="20466969"/>
          </a:xfrm>
        </p:spPr>
        <p:txBody>
          <a:bodyPr/>
          <a:lstStyle>
            <a:lvl1pPr>
              <a:defRPr sz="10079"/>
            </a:lvl1pPr>
            <a:lvl2pPr>
              <a:defRPr sz="8819"/>
            </a:lvl2pPr>
            <a:lvl3pPr>
              <a:defRPr sz="7559"/>
            </a:lvl3pPr>
            <a:lvl4pPr>
              <a:defRPr sz="6299"/>
            </a:lvl4pPr>
            <a:lvl5pPr>
              <a:defRPr sz="6299"/>
            </a:lvl5pPr>
            <a:lvl6pPr>
              <a:defRPr sz="6299"/>
            </a:lvl6pPr>
            <a:lvl7pPr>
              <a:defRPr sz="6299"/>
            </a:lvl7pPr>
            <a:lvl8pPr>
              <a:defRPr sz="6299"/>
            </a:lvl8pPr>
            <a:lvl9pPr>
              <a:defRPr sz="6299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83780" y="8640127"/>
            <a:ext cx="9288887" cy="16006905"/>
          </a:xfrm>
        </p:spPr>
        <p:txBody>
          <a:bodyPr/>
          <a:lstStyle>
            <a:lvl1pPr marL="0" indent="0">
              <a:buNone/>
              <a:defRPr sz="5040"/>
            </a:lvl1pPr>
            <a:lvl2pPr marL="1440043" indent="0">
              <a:buNone/>
              <a:defRPr sz="4410"/>
            </a:lvl2pPr>
            <a:lvl3pPr marL="2880086" indent="0">
              <a:buNone/>
              <a:defRPr sz="3780"/>
            </a:lvl3pPr>
            <a:lvl4pPr marL="4320129" indent="0">
              <a:buNone/>
              <a:defRPr sz="3150"/>
            </a:lvl4pPr>
            <a:lvl5pPr marL="5760171" indent="0">
              <a:buNone/>
              <a:defRPr sz="3150"/>
            </a:lvl5pPr>
            <a:lvl6pPr marL="7200214" indent="0">
              <a:buNone/>
              <a:defRPr sz="3150"/>
            </a:lvl6pPr>
            <a:lvl7pPr marL="8640257" indent="0">
              <a:buNone/>
              <a:defRPr sz="3150"/>
            </a:lvl7pPr>
            <a:lvl8pPr marL="10080300" indent="0">
              <a:buNone/>
              <a:defRPr sz="3150"/>
            </a:lvl8pPr>
            <a:lvl9pPr marL="11520343" indent="0">
              <a:buNone/>
              <a:defRPr sz="31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6F755-54B9-40FD-9AD7-93FB76274424}" type="datetimeFigureOut">
              <a:rPr lang="en-CA" smtClean="0"/>
              <a:t>2017-10-16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509B0-5F7A-46A0-A12E-40FDBD35201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5921618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83780" y="1920028"/>
            <a:ext cx="9288887" cy="6720099"/>
          </a:xfrm>
        </p:spPr>
        <p:txBody>
          <a:bodyPr anchor="b"/>
          <a:lstStyle>
            <a:lvl1pPr>
              <a:defRPr sz="10079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2243932" y="4146734"/>
            <a:ext cx="14580215" cy="20466969"/>
          </a:xfrm>
        </p:spPr>
        <p:txBody>
          <a:bodyPr anchor="t"/>
          <a:lstStyle>
            <a:lvl1pPr marL="0" indent="0">
              <a:buNone/>
              <a:defRPr sz="10079"/>
            </a:lvl1pPr>
            <a:lvl2pPr marL="1440043" indent="0">
              <a:buNone/>
              <a:defRPr sz="8819"/>
            </a:lvl2pPr>
            <a:lvl3pPr marL="2880086" indent="0">
              <a:buNone/>
              <a:defRPr sz="7559"/>
            </a:lvl3pPr>
            <a:lvl4pPr marL="4320129" indent="0">
              <a:buNone/>
              <a:defRPr sz="6299"/>
            </a:lvl4pPr>
            <a:lvl5pPr marL="5760171" indent="0">
              <a:buNone/>
              <a:defRPr sz="6299"/>
            </a:lvl5pPr>
            <a:lvl6pPr marL="7200214" indent="0">
              <a:buNone/>
              <a:defRPr sz="6299"/>
            </a:lvl6pPr>
            <a:lvl7pPr marL="8640257" indent="0">
              <a:buNone/>
              <a:defRPr sz="6299"/>
            </a:lvl7pPr>
            <a:lvl8pPr marL="10080300" indent="0">
              <a:buNone/>
              <a:defRPr sz="6299"/>
            </a:lvl8pPr>
            <a:lvl9pPr marL="11520343" indent="0">
              <a:buNone/>
              <a:defRPr sz="6299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83780" y="8640127"/>
            <a:ext cx="9288887" cy="16006905"/>
          </a:xfrm>
        </p:spPr>
        <p:txBody>
          <a:bodyPr/>
          <a:lstStyle>
            <a:lvl1pPr marL="0" indent="0">
              <a:buNone/>
              <a:defRPr sz="5040"/>
            </a:lvl1pPr>
            <a:lvl2pPr marL="1440043" indent="0">
              <a:buNone/>
              <a:defRPr sz="4410"/>
            </a:lvl2pPr>
            <a:lvl3pPr marL="2880086" indent="0">
              <a:buNone/>
              <a:defRPr sz="3780"/>
            </a:lvl3pPr>
            <a:lvl4pPr marL="4320129" indent="0">
              <a:buNone/>
              <a:defRPr sz="3150"/>
            </a:lvl4pPr>
            <a:lvl5pPr marL="5760171" indent="0">
              <a:buNone/>
              <a:defRPr sz="3150"/>
            </a:lvl5pPr>
            <a:lvl6pPr marL="7200214" indent="0">
              <a:buNone/>
              <a:defRPr sz="3150"/>
            </a:lvl6pPr>
            <a:lvl7pPr marL="8640257" indent="0">
              <a:buNone/>
              <a:defRPr sz="3150"/>
            </a:lvl7pPr>
            <a:lvl8pPr marL="10080300" indent="0">
              <a:buNone/>
              <a:defRPr sz="3150"/>
            </a:lvl8pPr>
            <a:lvl9pPr marL="11520343" indent="0">
              <a:buNone/>
              <a:defRPr sz="31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46F755-54B9-40FD-9AD7-93FB76274424}" type="datetimeFigureOut">
              <a:rPr lang="en-CA" smtClean="0"/>
              <a:t>2017-10-16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7509B0-5F7A-46A0-A12E-40FDBD35201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3068093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980029" y="1533362"/>
            <a:ext cx="24840367" cy="556675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980029" y="7666780"/>
            <a:ext cx="24840367" cy="1827360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980029" y="26693734"/>
            <a:ext cx="6480096" cy="153335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7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46F755-54B9-40FD-9AD7-93FB76274424}" type="datetimeFigureOut">
              <a:rPr lang="en-CA" smtClean="0"/>
              <a:t>2017-10-16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540141" y="26693734"/>
            <a:ext cx="9720143" cy="153335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7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0340300" y="26693734"/>
            <a:ext cx="6480096" cy="153335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78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7509B0-5F7A-46A0-A12E-40FDBD35201E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3830776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2880086" rtl="0" eaLnBrk="1" latinLnBrk="0" hangingPunct="1">
        <a:lnSpc>
          <a:spcPct val="90000"/>
        </a:lnSpc>
        <a:spcBef>
          <a:spcPct val="0"/>
        </a:spcBef>
        <a:buNone/>
        <a:defRPr sz="1385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720021" indent="-720021" algn="l" defTabSz="2880086" rtl="0" eaLnBrk="1" latinLnBrk="0" hangingPunct="1">
        <a:lnSpc>
          <a:spcPct val="90000"/>
        </a:lnSpc>
        <a:spcBef>
          <a:spcPts val="3150"/>
        </a:spcBef>
        <a:buFont typeface="Arial" panose="020B0604020202020204" pitchFamily="34" charset="0"/>
        <a:buChar char="•"/>
        <a:defRPr sz="8819" kern="1200">
          <a:solidFill>
            <a:schemeClr val="tx1"/>
          </a:solidFill>
          <a:latin typeface="+mn-lt"/>
          <a:ea typeface="+mn-ea"/>
          <a:cs typeface="+mn-cs"/>
        </a:defRPr>
      </a:lvl1pPr>
      <a:lvl2pPr marL="2160064" indent="-720021" algn="l" defTabSz="2880086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7559" kern="1200">
          <a:solidFill>
            <a:schemeClr val="tx1"/>
          </a:solidFill>
          <a:latin typeface="+mn-lt"/>
          <a:ea typeface="+mn-ea"/>
          <a:cs typeface="+mn-cs"/>
        </a:defRPr>
      </a:lvl2pPr>
      <a:lvl3pPr marL="3600107" indent="-720021" algn="l" defTabSz="2880086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6299" kern="1200">
          <a:solidFill>
            <a:schemeClr val="tx1"/>
          </a:solidFill>
          <a:latin typeface="+mn-lt"/>
          <a:ea typeface="+mn-ea"/>
          <a:cs typeface="+mn-cs"/>
        </a:defRPr>
      </a:lvl3pPr>
      <a:lvl4pPr marL="5040150" indent="-720021" algn="l" defTabSz="2880086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5669" kern="1200">
          <a:solidFill>
            <a:schemeClr val="tx1"/>
          </a:solidFill>
          <a:latin typeface="+mn-lt"/>
          <a:ea typeface="+mn-ea"/>
          <a:cs typeface="+mn-cs"/>
        </a:defRPr>
      </a:lvl4pPr>
      <a:lvl5pPr marL="6480193" indent="-720021" algn="l" defTabSz="2880086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5669" kern="1200">
          <a:solidFill>
            <a:schemeClr val="tx1"/>
          </a:solidFill>
          <a:latin typeface="+mn-lt"/>
          <a:ea typeface="+mn-ea"/>
          <a:cs typeface="+mn-cs"/>
        </a:defRPr>
      </a:lvl5pPr>
      <a:lvl6pPr marL="7920236" indent="-720021" algn="l" defTabSz="2880086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5669" kern="1200">
          <a:solidFill>
            <a:schemeClr val="tx1"/>
          </a:solidFill>
          <a:latin typeface="+mn-lt"/>
          <a:ea typeface="+mn-ea"/>
          <a:cs typeface="+mn-cs"/>
        </a:defRPr>
      </a:lvl6pPr>
      <a:lvl7pPr marL="9360278" indent="-720021" algn="l" defTabSz="2880086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5669" kern="1200">
          <a:solidFill>
            <a:schemeClr val="tx1"/>
          </a:solidFill>
          <a:latin typeface="+mn-lt"/>
          <a:ea typeface="+mn-ea"/>
          <a:cs typeface="+mn-cs"/>
        </a:defRPr>
      </a:lvl7pPr>
      <a:lvl8pPr marL="10800321" indent="-720021" algn="l" defTabSz="2880086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5669" kern="1200">
          <a:solidFill>
            <a:schemeClr val="tx1"/>
          </a:solidFill>
          <a:latin typeface="+mn-lt"/>
          <a:ea typeface="+mn-ea"/>
          <a:cs typeface="+mn-cs"/>
        </a:defRPr>
      </a:lvl8pPr>
      <a:lvl9pPr marL="12240364" indent="-720021" algn="l" defTabSz="2880086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566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880086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1pPr>
      <a:lvl2pPr marL="1440043" algn="l" defTabSz="2880086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2pPr>
      <a:lvl3pPr marL="2880086" algn="l" defTabSz="2880086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3pPr>
      <a:lvl4pPr marL="4320129" algn="l" defTabSz="2880086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4pPr>
      <a:lvl5pPr marL="5760171" algn="l" defTabSz="2880086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5pPr>
      <a:lvl6pPr marL="7200214" algn="l" defTabSz="2880086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6pPr>
      <a:lvl7pPr marL="8640257" algn="l" defTabSz="2880086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7pPr>
      <a:lvl8pPr marL="10080300" algn="l" defTabSz="2880086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8pPr>
      <a:lvl9pPr marL="11520343" algn="l" defTabSz="2880086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4" Type="http://schemas.openxmlformats.org/officeDocument/2006/relationships/image" Target="../media/image2.jpeg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4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4" Type="http://schemas.openxmlformats.org/officeDocument/2006/relationships/image" Target="../media/image5.png"/><Relationship Id="rId5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3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chart" Target="../charts/chart2.xml"/><Relationship Id="rId3" Type="http://schemas.openxmlformats.org/officeDocument/2006/relationships/chart" Target="../charts/chart3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4.xml"/><Relationship Id="rId4" Type="http://schemas.openxmlformats.org/officeDocument/2006/relationships/chart" Target="../charts/chart5.xml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4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4" Type="http://schemas.openxmlformats.org/officeDocument/2006/relationships/chart" Target="../charts/chart7.xml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177" r="20487"/>
          <a:stretch/>
        </p:blipFill>
        <p:spPr>
          <a:xfrm rot="5400000">
            <a:off x="4650574" y="9950677"/>
            <a:ext cx="9469842" cy="9626364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323" t="3903" r="24725" b="8455"/>
          <a:stretch/>
        </p:blipFill>
        <p:spPr>
          <a:xfrm flipH="1" flipV="1">
            <a:off x="14380501" y="10028937"/>
            <a:ext cx="9979354" cy="9469844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969507" y="5535342"/>
            <a:ext cx="4434079" cy="12207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7333" dirty="0">
                <a:latin typeface="Times" panose="02020603050405020304" pitchFamily="18" charset="0"/>
                <a:cs typeface="Times" panose="02020603050405020304" pitchFamily="18" charset="0"/>
              </a:rPr>
              <a:t>Figure S1</a:t>
            </a:r>
          </a:p>
        </p:txBody>
      </p:sp>
      <p:sp>
        <p:nvSpPr>
          <p:cNvPr id="3" name="TextBox 2"/>
          <p:cNvSpPr txBox="1"/>
          <p:nvPr/>
        </p:nvSpPr>
        <p:spPr>
          <a:xfrm>
            <a:off x="6096432" y="9197687"/>
            <a:ext cx="2282869" cy="8445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4888" dirty="0">
                <a:latin typeface="Times" panose="02020603050405020304" pitchFamily="18" charset="0"/>
                <a:cs typeface="Times" panose="02020603050405020304" pitchFamily="18" charset="0"/>
              </a:rPr>
              <a:t>Control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5719431" y="9157929"/>
            <a:ext cx="2282869" cy="8445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4888" dirty="0">
                <a:latin typeface="Times" panose="02020603050405020304" pitchFamily="18" charset="0"/>
                <a:cs typeface="Times" panose="02020603050405020304" pitchFamily="18" charset="0"/>
              </a:rPr>
              <a:t>Control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0639932" y="9206512"/>
            <a:ext cx="2282869" cy="8445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4888" dirty="0">
                <a:latin typeface="Times" panose="02020603050405020304" pitchFamily="18" charset="0"/>
                <a:cs typeface="Times" panose="02020603050405020304" pitchFamily="18" charset="0"/>
              </a:rPr>
              <a:t>Infected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21104575" y="9086588"/>
            <a:ext cx="2282869" cy="8445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4888" dirty="0">
                <a:latin typeface="Times" panose="02020603050405020304" pitchFamily="18" charset="0"/>
                <a:cs typeface="Times" panose="02020603050405020304" pitchFamily="18" charset="0"/>
              </a:rPr>
              <a:t>Infected</a:t>
            </a:r>
          </a:p>
        </p:txBody>
      </p:sp>
      <p:sp>
        <p:nvSpPr>
          <p:cNvPr id="12" name="Right Bracket 11"/>
          <p:cNvSpPr/>
          <p:nvPr/>
        </p:nvSpPr>
        <p:spPr>
          <a:xfrm rot="16200000">
            <a:off x="9262065" y="6527169"/>
            <a:ext cx="259255" cy="5018623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CA" sz="4888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13" name="Right Bracket 12"/>
          <p:cNvSpPr/>
          <p:nvPr/>
        </p:nvSpPr>
        <p:spPr>
          <a:xfrm rot="16200000">
            <a:off x="19240551" y="6464009"/>
            <a:ext cx="259255" cy="5018623"/>
          </a:xfrm>
          <a:prstGeom prst="rightBracket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CA" sz="4888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8628640" y="7990175"/>
            <a:ext cx="2282869" cy="8445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4888" dirty="0">
                <a:latin typeface="Times" panose="02020603050405020304" pitchFamily="18" charset="0"/>
                <a:cs typeface="Times" panose="02020603050405020304" pitchFamily="18" charset="0"/>
              </a:rPr>
              <a:t>24 dpi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8357064" y="7995633"/>
            <a:ext cx="2282869" cy="8445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4888" dirty="0">
                <a:latin typeface="Times" panose="02020603050405020304" pitchFamily="18" charset="0"/>
                <a:cs typeface="Times" panose="02020603050405020304" pitchFamily="18" charset="0"/>
              </a:rPr>
              <a:t>20 dpi</a:t>
            </a:r>
          </a:p>
        </p:txBody>
      </p:sp>
    </p:spTree>
    <p:extLst>
      <p:ext uri="{BB962C8B-B14F-4D97-AF65-F5344CB8AC3E}">
        <p14:creationId xmlns:p14="http://schemas.microsoft.com/office/powerpoint/2010/main" val="18156455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581268" y="325321"/>
            <a:ext cx="22788667" cy="12823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7733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endParaRPr lang="en-CA" sz="488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760314" y="2244021"/>
            <a:ext cx="1759851" cy="12823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7733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graphicFrame>
        <p:nvGraphicFramePr>
          <p:cNvPr id="10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79915976"/>
              </p:ext>
            </p:extLst>
          </p:nvPr>
        </p:nvGraphicFramePr>
        <p:xfrm>
          <a:off x="1058349" y="2244021"/>
          <a:ext cx="28403551" cy="133226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2" name="TextBox 11"/>
          <p:cNvSpPr txBox="1"/>
          <p:nvPr/>
        </p:nvSpPr>
        <p:spPr>
          <a:xfrm>
            <a:off x="6022743" y="15958574"/>
            <a:ext cx="1759851" cy="12823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7733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grpSp>
        <p:nvGrpSpPr>
          <p:cNvPr id="13" name="Group 12"/>
          <p:cNvGrpSpPr/>
          <p:nvPr/>
        </p:nvGrpSpPr>
        <p:grpSpPr>
          <a:xfrm>
            <a:off x="7203808" y="15958574"/>
            <a:ext cx="18862663" cy="12246685"/>
            <a:chOff x="2779462" y="5355773"/>
            <a:chExt cx="25273022" cy="16147963"/>
          </a:xfrm>
        </p:grpSpPr>
        <p:pic>
          <p:nvPicPr>
            <p:cNvPr id="14" name="Picture 13"/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35" t="13956" r="10554" b="17051"/>
            <a:stretch/>
          </p:blipFill>
          <p:spPr>
            <a:xfrm>
              <a:off x="3755571" y="5355773"/>
              <a:ext cx="20541342" cy="14793686"/>
            </a:xfrm>
            <a:prstGeom prst="rect">
              <a:avLst/>
            </a:prstGeom>
          </p:spPr>
        </p:pic>
        <p:sp>
          <p:nvSpPr>
            <p:cNvPr id="15" name="TextBox 14"/>
            <p:cNvSpPr txBox="1"/>
            <p:nvPr/>
          </p:nvSpPr>
          <p:spPr>
            <a:xfrm>
              <a:off x="24296913" y="11596986"/>
              <a:ext cx="3755571" cy="26999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2800" dirty="0" smtClean="0">
                  <a:latin typeface="Times" panose="02020603050405020304" pitchFamily="18" charset="0"/>
                  <a:cs typeface="Times" panose="02020603050405020304" pitchFamily="18" charset="0"/>
                </a:rPr>
                <a:t>Control Shoot</a:t>
              </a:r>
            </a:p>
            <a:p>
              <a:r>
                <a:rPr lang="en-CA" sz="2800" dirty="0" smtClean="0">
                  <a:latin typeface="Times" panose="02020603050405020304" pitchFamily="18" charset="0"/>
                  <a:cs typeface="Times" panose="02020603050405020304" pitchFamily="18" charset="0"/>
                </a:rPr>
                <a:t>Control Root</a:t>
              </a:r>
            </a:p>
            <a:p>
              <a:r>
                <a:rPr lang="en-CA" sz="2800" dirty="0" smtClean="0">
                  <a:latin typeface="Times" panose="02020603050405020304" pitchFamily="18" charset="0"/>
                  <a:cs typeface="Times" panose="02020603050405020304" pitchFamily="18" charset="0"/>
                </a:rPr>
                <a:t>Infected Shoot</a:t>
              </a:r>
            </a:p>
            <a:p>
              <a:r>
                <a:rPr lang="en-CA" sz="2800" dirty="0" smtClean="0">
                  <a:latin typeface="Times" panose="02020603050405020304" pitchFamily="18" charset="0"/>
                  <a:cs typeface="Times" panose="02020603050405020304" pitchFamily="18" charset="0"/>
                </a:rPr>
                <a:t>Infected Root</a:t>
              </a:r>
              <a:endParaRPr lang="en-CA" sz="2800" dirty="0">
                <a:latin typeface="Times" panose="02020603050405020304" pitchFamily="18" charset="0"/>
                <a:cs typeface="Times" panose="02020603050405020304" pitchFamily="18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 rot="16200000">
              <a:off x="-954931" y="10781004"/>
              <a:ext cx="8284512" cy="81572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3200" dirty="0" smtClean="0">
                  <a:latin typeface="Times" panose="02020603050405020304" pitchFamily="18" charset="0"/>
                  <a:cs typeface="Times" panose="02020603050405020304" pitchFamily="18" charset="0"/>
                </a:rPr>
                <a:t>PC2 (10.5% explained var.)</a:t>
              </a:r>
              <a:endParaRPr lang="en-CA" sz="3200" dirty="0">
                <a:latin typeface="Times" panose="02020603050405020304" pitchFamily="18" charset="0"/>
                <a:cs typeface="Times" panose="02020603050405020304" pitchFamily="18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10466766" y="20666203"/>
              <a:ext cx="7773087" cy="8375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CA" sz="3200" dirty="0" smtClean="0">
                  <a:latin typeface="Times" panose="02020603050405020304" pitchFamily="18" charset="0"/>
                  <a:cs typeface="Times" panose="02020603050405020304" pitchFamily="18" charset="0"/>
                </a:rPr>
                <a:t>PC1 (31.1% explained var.)</a:t>
              </a:r>
              <a:endParaRPr lang="en-CA" sz="3200" dirty="0">
                <a:latin typeface="Times" panose="02020603050405020304" pitchFamily="18" charset="0"/>
                <a:cs typeface="Times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77766611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581268" y="325321"/>
            <a:ext cx="22788667" cy="12823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7733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CA" sz="7733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CA" sz="7733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en-CA" sz="488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108123" y="4153668"/>
            <a:ext cx="2261812" cy="2060627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6673848" y="4445276"/>
            <a:ext cx="1759851" cy="12823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7733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1268" y="6214295"/>
            <a:ext cx="12876918" cy="16664247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184538" y="6323743"/>
            <a:ext cx="12792345" cy="165547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5353800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415014" y="325321"/>
            <a:ext cx="22788667" cy="12823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7733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CA" sz="7733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CA" sz="7733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lang="en-CA" sz="488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69523824"/>
              </p:ext>
            </p:extLst>
          </p:nvPr>
        </p:nvGraphicFramePr>
        <p:xfrm>
          <a:off x="3102429" y="2762633"/>
          <a:ext cx="24264257" cy="1085539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26345914"/>
              </p:ext>
            </p:extLst>
          </p:nvPr>
        </p:nvGraphicFramePr>
        <p:xfrm>
          <a:off x="3102429" y="14773002"/>
          <a:ext cx="23839714" cy="1156062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0" name="TextBox 9"/>
          <p:cNvSpPr txBox="1"/>
          <p:nvPr/>
        </p:nvSpPr>
        <p:spPr>
          <a:xfrm>
            <a:off x="937831" y="3322293"/>
            <a:ext cx="1759851" cy="12823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7733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937831" y="14916597"/>
            <a:ext cx="1759851" cy="12823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7733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65432774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4643557" y="5872988"/>
            <a:ext cx="1759851" cy="12823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7733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4922118" y="14633552"/>
            <a:ext cx="1759851" cy="12823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7733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726168" y="1900156"/>
            <a:ext cx="5075875" cy="12823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7733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CA" sz="7733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5</a:t>
            </a:r>
            <a:endParaRPr lang="en-CA" sz="773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1" name="Chart 2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02691483"/>
              </p:ext>
            </p:extLst>
          </p:nvPr>
        </p:nvGraphicFramePr>
        <p:xfrm>
          <a:off x="5394969" y="3690257"/>
          <a:ext cx="22396260" cy="1222563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22" name="Group 21"/>
          <p:cNvGrpSpPr/>
          <p:nvPr/>
        </p:nvGrpSpPr>
        <p:grpSpPr>
          <a:xfrm>
            <a:off x="22121034" y="5375358"/>
            <a:ext cx="3577931" cy="7262956"/>
            <a:chOff x="7108884" y="63148"/>
            <a:chExt cx="1652493" cy="3354448"/>
          </a:xfrm>
        </p:grpSpPr>
        <p:cxnSp>
          <p:nvCxnSpPr>
            <p:cNvPr id="23" name="Straight Connector 22"/>
            <p:cNvCxnSpPr>
              <a:cxnSpLocks/>
            </p:cNvCxnSpPr>
            <p:nvPr/>
          </p:nvCxnSpPr>
          <p:spPr>
            <a:xfrm flipH="1">
              <a:off x="8760251" y="63148"/>
              <a:ext cx="1126" cy="1659034"/>
            </a:xfrm>
            <a:prstGeom prst="line">
              <a:avLst/>
            </a:prstGeom>
            <a:ln w="12700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/>
            <p:cNvCxnSpPr>
              <a:cxnSpLocks/>
            </p:cNvCxnSpPr>
            <p:nvPr/>
          </p:nvCxnSpPr>
          <p:spPr>
            <a:xfrm flipH="1">
              <a:off x="7108884" y="1722183"/>
              <a:ext cx="1652493" cy="1695413"/>
            </a:xfrm>
            <a:prstGeom prst="line">
              <a:avLst/>
            </a:prstGeom>
            <a:ln w="12700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aphicFrame>
        <p:nvGraphicFramePr>
          <p:cNvPr id="13" name="Chart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78907960"/>
              </p:ext>
            </p:extLst>
          </p:nvPr>
        </p:nvGraphicFramePr>
        <p:xfrm>
          <a:off x="6485839" y="13618028"/>
          <a:ext cx="22396260" cy="1149270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pSp>
        <p:nvGrpSpPr>
          <p:cNvPr id="14" name="Group 13"/>
          <p:cNvGrpSpPr/>
          <p:nvPr/>
        </p:nvGrpSpPr>
        <p:grpSpPr>
          <a:xfrm>
            <a:off x="21811796" y="14924314"/>
            <a:ext cx="3577931" cy="7264136"/>
            <a:chOff x="7108884" y="-182296"/>
            <a:chExt cx="1652493" cy="3599892"/>
          </a:xfrm>
        </p:grpSpPr>
        <p:cxnSp>
          <p:nvCxnSpPr>
            <p:cNvPr id="15" name="Straight Connector 14"/>
            <p:cNvCxnSpPr>
              <a:cxnSpLocks/>
            </p:cNvCxnSpPr>
            <p:nvPr/>
          </p:nvCxnSpPr>
          <p:spPr>
            <a:xfrm flipH="1">
              <a:off x="8760251" y="-182296"/>
              <a:ext cx="1126" cy="1904478"/>
            </a:xfrm>
            <a:prstGeom prst="line">
              <a:avLst/>
            </a:prstGeom>
            <a:ln w="12700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" name="Straight Connector 15"/>
            <p:cNvCxnSpPr>
              <a:cxnSpLocks/>
            </p:cNvCxnSpPr>
            <p:nvPr/>
          </p:nvCxnSpPr>
          <p:spPr>
            <a:xfrm flipH="1">
              <a:off x="7108884" y="1722183"/>
              <a:ext cx="1652493" cy="1695413"/>
            </a:xfrm>
            <a:prstGeom prst="line">
              <a:avLst/>
            </a:prstGeom>
            <a:ln w="12700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40793921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6094977" y="3975575"/>
            <a:ext cx="1759851" cy="12823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7733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6094978" y="13295569"/>
            <a:ext cx="1759851" cy="12823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7733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327664" y="1729886"/>
            <a:ext cx="5031471" cy="12823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7733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CA" sz="7733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6</a:t>
            </a:r>
            <a:endParaRPr lang="en-CA" sz="773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4" name="Chart 13">
            <a:extLst>
              <a:ext uri="{FF2B5EF4-FFF2-40B4-BE49-F238E27FC236}">
                <a16:creationId xmlns:xdr="http://schemas.openxmlformats.org/drawingml/2006/spreadsheetDrawing" xmlns:a16="http://schemas.microsoft.com/office/drawing/2014/main" xmlns="" xmlns:lc="http://schemas.openxmlformats.org/drawingml/2006/lockedCanvas" id="{00000000-0008-0000-0100-000003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96301689"/>
              </p:ext>
            </p:extLst>
          </p:nvPr>
        </p:nvGraphicFramePr>
        <p:xfrm>
          <a:off x="6140619" y="3923754"/>
          <a:ext cx="21631274" cy="981681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9" name="Chart 18">
            <a:extLst>
              <a:ext uri="{FF2B5EF4-FFF2-40B4-BE49-F238E27FC236}">
                <a16:creationId xmlns:xdr="http://schemas.openxmlformats.org/drawingml/2006/spreadsheetDrawing" xmlns="" xmlns:a16="http://schemas.microsoft.com/office/drawing/2014/main" xmlns:lc="http://schemas.openxmlformats.org/drawingml/2006/lockedCanvas" id="{00000000-0008-0000-0100-000004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79783793"/>
              </p:ext>
            </p:extLst>
          </p:nvPr>
        </p:nvGraphicFramePr>
        <p:xfrm>
          <a:off x="6140618" y="13085722"/>
          <a:ext cx="21676916" cy="98459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pSp>
        <p:nvGrpSpPr>
          <p:cNvPr id="26" name="Group 25"/>
          <p:cNvGrpSpPr/>
          <p:nvPr/>
        </p:nvGrpSpPr>
        <p:grpSpPr>
          <a:xfrm>
            <a:off x="15806056" y="14577908"/>
            <a:ext cx="4567800" cy="7848599"/>
            <a:chOff x="6651706" y="288899"/>
            <a:chExt cx="2109671" cy="3624932"/>
          </a:xfrm>
        </p:grpSpPr>
        <p:cxnSp>
          <p:nvCxnSpPr>
            <p:cNvPr id="27" name="Straight Connector 26"/>
            <p:cNvCxnSpPr>
              <a:cxnSpLocks/>
            </p:cNvCxnSpPr>
            <p:nvPr/>
          </p:nvCxnSpPr>
          <p:spPr>
            <a:xfrm flipH="1">
              <a:off x="8760253" y="288899"/>
              <a:ext cx="1123" cy="1472999"/>
            </a:xfrm>
            <a:prstGeom prst="line">
              <a:avLst/>
            </a:prstGeom>
            <a:ln w="12700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Connector 27"/>
            <p:cNvCxnSpPr>
              <a:cxnSpLocks/>
            </p:cNvCxnSpPr>
            <p:nvPr/>
          </p:nvCxnSpPr>
          <p:spPr>
            <a:xfrm flipH="1">
              <a:off x="6651706" y="1752349"/>
              <a:ext cx="2109671" cy="2161482"/>
            </a:xfrm>
            <a:prstGeom prst="line">
              <a:avLst/>
            </a:prstGeom>
            <a:ln w="12700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9" name="Group 28"/>
          <p:cNvGrpSpPr/>
          <p:nvPr/>
        </p:nvGrpSpPr>
        <p:grpSpPr>
          <a:xfrm>
            <a:off x="17504229" y="5237124"/>
            <a:ext cx="3910863" cy="7042898"/>
            <a:chOff x="6955117" y="288899"/>
            <a:chExt cx="1806260" cy="3252813"/>
          </a:xfrm>
        </p:grpSpPr>
        <p:cxnSp>
          <p:nvCxnSpPr>
            <p:cNvPr id="30" name="Straight Connector 29"/>
            <p:cNvCxnSpPr>
              <a:cxnSpLocks/>
            </p:cNvCxnSpPr>
            <p:nvPr/>
          </p:nvCxnSpPr>
          <p:spPr>
            <a:xfrm flipH="1">
              <a:off x="8760253" y="288899"/>
              <a:ext cx="1123" cy="1472999"/>
            </a:xfrm>
            <a:prstGeom prst="line">
              <a:avLst/>
            </a:prstGeom>
            <a:ln w="12700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Connector 30"/>
            <p:cNvCxnSpPr>
              <a:cxnSpLocks/>
            </p:cNvCxnSpPr>
            <p:nvPr/>
          </p:nvCxnSpPr>
          <p:spPr>
            <a:xfrm flipH="1">
              <a:off x="6955117" y="1752349"/>
              <a:ext cx="1806260" cy="1789363"/>
            </a:xfrm>
            <a:prstGeom prst="line">
              <a:avLst/>
            </a:prstGeom>
            <a:ln w="12700">
              <a:solidFill>
                <a:schemeClr val="bg1">
                  <a:lumMod val="50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41209579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57</TotalTime>
  <Words>88</Words>
  <Application>Microsoft Macintosh PowerPoint</Application>
  <PresentationFormat>Custom</PresentationFormat>
  <Paragraphs>39</Paragraphs>
  <Slides>6</Slides>
  <Notes>5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2" baseType="lpstr">
      <vt:lpstr>Calibri</vt:lpstr>
      <vt:lpstr>Calibri Light</vt:lpstr>
      <vt:lpstr>Times</vt:lpstr>
      <vt:lpstr>Times New Roman</vt:lpstr>
      <vt:lpstr>Arial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38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Irani, Solmaz</dc:creator>
  <cp:lastModifiedBy>Peta Bonham-Smith</cp:lastModifiedBy>
  <cp:revision>171</cp:revision>
  <dcterms:created xsi:type="dcterms:W3CDTF">2017-02-10T20:58:51Z</dcterms:created>
  <dcterms:modified xsi:type="dcterms:W3CDTF">2017-10-16T15:24:42Z</dcterms:modified>
</cp:coreProperties>
</file>